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colors5.xml" ContentType="application/vnd.ms-office.chartcolorstyle+xml"/>
  <Override PartName="/ppt/charts/colors6.xml" ContentType="application/vnd.ms-office.chartcolorstyle+xml"/>
  <Override PartName="/ppt/charts/colors7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charts/style5.xml" ContentType="application/vnd.ms-office.chartstyle+xml"/>
  <Override PartName="/ppt/charts/style6.xml" ContentType="application/vnd.ms-office.chartstyle+xml"/>
  <Override PartName="/ppt/charts/style7.xml" ContentType="application/vnd.ms-office.chartstyle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311" r:id="rId2"/>
    <p:sldId id="302" r:id="rId3"/>
    <p:sldId id="303" r:id="rId4"/>
    <p:sldId id="304" r:id="rId5"/>
    <p:sldId id="307" r:id="rId6"/>
    <p:sldId id="308" r:id="rId7"/>
    <p:sldId id="309" r:id="rId8"/>
    <p:sldId id="310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notesMaster" Target="notesMasters/notesMaster1.xml"/>
   <Relationship Id="rId11" Type="http://schemas.openxmlformats.org/officeDocument/2006/relationships/presProps" Target="presProps.xml"/>
   <Relationship Id="rId12" Type="http://schemas.openxmlformats.org/officeDocument/2006/relationships/viewProps" Target="viewProps.xml"/>
   <Relationship Id="rId13" Type="http://schemas.openxmlformats.org/officeDocument/2006/relationships/theme" Target="theme/theme1.xml"/>
   <Relationship Id="rId14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slide" Target="slides/slide6.xml"/>
   <Relationship Id="rId8" Type="http://schemas.openxmlformats.org/officeDocument/2006/relationships/slide" Target="slides/slide7.xml"/>
   <Relationship Id="rId9" Type="http://schemas.openxmlformats.org/officeDocument/2006/relationships/slide" Target="slides/slide8.xml"/>
</Relationships>
</file>

<file path=ppt/charts/_rels/chart1.xml.rels><?xml version = '1.0' encoding = 'UTF-8' standalone = 'yes'?>
<Relationships xmlns="http://schemas.openxmlformats.org/package/2006/relationships">
   <Relationship Id="rId1" Type="http://schemas.microsoft.com/office/2011/relationships/chartStyle" Target="style1.xml"/>
   <Relationship Id="rId2" Type="http://schemas.microsoft.com/office/2011/relationships/chartColorStyle" Target="colors1.xml"/>
   <Relationship Id="rId3" Type="http://schemas.openxmlformats.org/officeDocument/2006/relationships/oleObject" TargetMode="External" Target="file:///C:/Users/gglinsky/Desktop/2015_2016%20VittorioS/2016_CSC%20VittorioS/HPATs%20BLastocyst%20Cells/HPATclassification.xlsx"/>
</Relationships>
</file>

<file path=ppt/charts/_rels/chart2.xml.rels><?xml version = '1.0' encoding = 'UTF-8' standalone = 'yes'?>
<Relationships xmlns="http://schemas.openxmlformats.org/package/2006/relationships">
   <Relationship Id="rId1" Type="http://schemas.microsoft.com/office/2011/relationships/chartStyle" Target="style2.xml"/>
   <Relationship Id="rId2" Type="http://schemas.microsoft.com/office/2011/relationships/chartColorStyle" Target="colors2.xml"/>
   <Relationship Id="rId3" Type="http://schemas.openxmlformats.org/officeDocument/2006/relationships/oleObject" TargetMode="External" Target="file:///C:/Users/gglinsky/Desktop/2015_2016%20VittorioS/2016_CSC%20VittorioS/HPATs%20BLastocyst%20Cells/HPATclassification.xlsx"/>
</Relationships>
</file>

<file path=ppt/charts/_rels/chart3.xml.rels><?xml version = '1.0' encoding = 'UTF-8' standalone = 'yes'?>
<Relationships xmlns="http://schemas.openxmlformats.org/package/2006/relationships">
   <Relationship Id="rId1" Type="http://schemas.microsoft.com/office/2011/relationships/chartStyle" Target="style3.xml"/>
   <Relationship Id="rId2" Type="http://schemas.microsoft.com/office/2011/relationships/chartColorStyle" Target="colors3.xml"/>
   <Relationship Id="rId3" Type="http://schemas.openxmlformats.org/officeDocument/2006/relationships/oleObject" TargetMode="External" Target="file:///C:/Users/gglinsky/Desktop/2015_2016%20VittorioS/2016_CSC%20VittorioS/HPATs%20BLastocyst%20Cells/HPATclassification.xlsx"/>
</Relationships>
</file>

<file path=ppt/charts/_rels/chart4.xml.rels><?xml version = '1.0' encoding = 'UTF-8' standalone = 'yes'?>
<Relationships xmlns="http://schemas.openxmlformats.org/package/2006/relationships">
   <Relationship Id="rId1" Type="http://schemas.microsoft.com/office/2011/relationships/chartStyle" Target="style4.xml"/>
   <Relationship Id="rId2" Type="http://schemas.microsoft.com/office/2011/relationships/chartColorStyle" Target="colors4.xml"/>
   <Relationship Id="rId3" Type="http://schemas.openxmlformats.org/officeDocument/2006/relationships/oleObject" TargetMode="External" Target="file:///C:/Users/gglinsky/Desktop/2015_2016%20VittorioS/2016_CSC%20VittorioS/HPATs%20BLastocyst%20Cells/HPATclassification.xlsx"/>
</Relationships>
</file>

<file path=ppt/charts/_rels/chart5.xml.rels><?xml version = '1.0' encoding = 'UTF-8' standalone = 'yes'?>
<Relationships xmlns="http://schemas.openxmlformats.org/package/2006/relationships">
   <Relationship Id="rId1" Type="http://schemas.microsoft.com/office/2011/relationships/chartStyle" Target="style5.xml"/>
   <Relationship Id="rId2" Type="http://schemas.microsoft.com/office/2011/relationships/chartColorStyle" Target="colors5.xml"/>
   <Relationship Id="rId3" Type="http://schemas.openxmlformats.org/officeDocument/2006/relationships/oleObject" TargetMode="External" Target="file:///C:/Users/gglinsky/Desktop/HPATs%20Blastocysts.xlsx"/>
</Relationships>
</file>

<file path=ppt/charts/_rels/chart6.xml.rels><?xml version = '1.0' encoding = 'UTF-8' standalone = 'yes'?>
<Relationships xmlns="http://schemas.openxmlformats.org/package/2006/relationships">
   <Relationship Id="rId1" Type="http://schemas.microsoft.com/office/2011/relationships/chartStyle" Target="style6.xml"/>
   <Relationship Id="rId2" Type="http://schemas.microsoft.com/office/2011/relationships/chartColorStyle" Target="colors6.xml"/>
   <Relationship Id="rId3" Type="http://schemas.openxmlformats.org/officeDocument/2006/relationships/oleObject" TargetMode="External" Target="file:///C:/Users/gglinsky/Desktop/2015_2016%20VittorioS/2016_CSC%20VittorioS/HPATs%20BLastocyst%20Cells/HPATs%20Blastocysts.xlsx"/>
</Relationships>
</file>

<file path=ppt/charts/_rels/chart7.xml.rels><?xml version = '1.0' encoding = 'UTF-8' standalone = 'yes'?>
<Relationships xmlns="http://schemas.openxmlformats.org/package/2006/relationships">
   <Relationship Id="rId1" Type="http://schemas.microsoft.com/office/2011/relationships/chartStyle" Target="style7.xml"/>
   <Relationship Id="rId2" Type="http://schemas.microsoft.com/office/2011/relationships/chartColorStyle" Target="colors7.xml"/>
   <Relationship Id="rId3" Type="http://schemas.openxmlformats.org/officeDocument/2006/relationships/oleObject" TargetMode="External" Target="file:///C:/Users/gglinsky/Desktop/HPATs%20Blastocysts.xlsx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600" b="1">
                <a:solidFill>
                  <a:sysClr val="windowText" lastClr="000000"/>
                </a:solidFill>
              </a:rPr>
              <a:t>DIFFERENTIATION</a:t>
            </a:r>
            <a:r>
              <a:rPr lang="en-US" sz="1600" b="1" baseline="0">
                <a:solidFill>
                  <a:sysClr val="windowText" lastClr="000000"/>
                </a:solidFill>
              </a:rPr>
              <a:t> PATTERNS OF PE-LIKE CELLS' MARKERS</a:t>
            </a:r>
            <a:endParaRPr lang="en-US" sz="1600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6816153953052665"/>
          <c:y val="0.14824068906411242"/>
          <c:w val="0.81571396319136236"/>
          <c:h val="0.73924672966445171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Figures!$B$15</c:f>
              <c:strCache>
                <c:ptCount val="1"/>
                <c:pt idx="0">
                  <c:v>FGFR2 (+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Figures!$C$14:$F$14</c:f>
              <c:strCache>
                <c:ptCount val="4"/>
                <c:pt idx="0">
                  <c:v>Early HPAT21/HPAT15</c:v>
                </c:pt>
                <c:pt idx="1">
                  <c:v>Late HPAT21/HPAT15</c:v>
                </c:pt>
                <c:pt idx="2">
                  <c:v>Early HPAT21</c:v>
                </c:pt>
                <c:pt idx="3">
                  <c:v>Late HPAT21</c:v>
                </c:pt>
              </c:strCache>
            </c:strRef>
          </c:cat>
          <c:val>
            <c:numRef>
              <c:f>Figures!$C$15:$F$15</c:f>
              <c:numCache>
                <c:formatCode>0.0</c:formatCode>
                <c:ptCount val="4"/>
                <c:pt idx="0">
                  <c:v>55.555555555555557</c:v>
                </c:pt>
                <c:pt idx="1">
                  <c:v>3.5087719298245612</c:v>
                </c:pt>
                <c:pt idx="2">
                  <c:v>45.454545454545453</c:v>
                </c:pt>
                <c:pt idx="3">
                  <c:v>10.16949152542373</c:v>
                </c:pt>
              </c:numCache>
            </c:numRef>
          </c:val>
        </c:ser>
        <c:ser>
          <c:idx val="1"/>
          <c:order val="1"/>
          <c:tx>
            <c:strRef>
              <c:f>Figures!$B$16</c:f>
              <c:strCache>
                <c:ptCount val="1"/>
                <c:pt idx="0">
                  <c:v>GATA4 (+)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  <a:sp3d>
              <a:contourClr>
                <a:srgbClr val="FF0000"/>
              </a:contourClr>
            </a:sp3d>
          </c:spPr>
          <c:invertIfNegative val="0"/>
          <c:cat>
            <c:strRef>
              <c:f>Figures!$C$14:$F$14</c:f>
              <c:strCache>
                <c:ptCount val="4"/>
                <c:pt idx="0">
                  <c:v>Early HPAT21/HPAT15</c:v>
                </c:pt>
                <c:pt idx="1">
                  <c:v>Late HPAT21/HPAT15</c:v>
                </c:pt>
                <c:pt idx="2">
                  <c:v>Early HPAT21</c:v>
                </c:pt>
                <c:pt idx="3">
                  <c:v>Late HPAT21</c:v>
                </c:pt>
              </c:strCache>
            </c:strRef>
          </c:cat>
          <c:val>
            <c:numRef>
              <c:f>Figures!$C$16:$F$16</c:f>
              <c:numCache>
                <c:formatCode>0.0</c:formatCode>
                <c:ptCount val="4"/>
                <c:pt idx="0">
                  <c:v>14.814814814814813</c:v>
                </c:pt>
                <c:pt idx="1">
                  <c:v>45.614035087719294</c:v>
                </c:pt>
                <c:pt idx="2">
                  <c:v>45.454545454545453</c:v>
                </c:pt>
                <c:pt idx="3">
                  <c:v>5.0847457627118651</c:v>
                </c:pt>
              </c:numCache>
            </c:numRef>
          </c:val>
          <c:shape val="cylinder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65984888"/>
        <c:axId val="265987240"/>
        <c:axId val="0"/>
      </c:bar3DChart>
      <c:catAx>
        <c:axId val="265984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7240"/>
        <c:crosses val="autoZero"/>
        <c:auto val="1"/>
        <c:lblAlgn val="ctr"/>
        <c:lblOffset val="100"/>
        <c:noMultiLvlLbl val="0"/>
      </c:catAx>
      <c:valAx>
        <c:axId val="2659872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chemeClr val="tx1"/>
                    </a:solidFill>
                  </a:rPr>
                  <a:t>PERCENT</a:t>
                </a:r>
                <a:r>
                  <a:rPr lang="en-US" sz="1600" b="1" baseline="0">
                    <a:solidFill>
                      <a:schemeClr val="tx1"/>
                    </a:solidFill>
                  </a:rPr>
                  <a:t> OF POSITIVE CELLS</a:t>
                </a:r>
                <a:endParaRPr lang="en-US" sz="1600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5.3207147503715448E-2"/>
              <c:y val="0.352780123101678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48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600" b="1">
                <a:solidFill>
                  <a:sysClr val="windowText" lastClr="000000"/>
                </a:solidFill>
              </a:rPr>
              <a:t>DIFFERENTIATION</a:t>
            </a:r>
            <a:r>
              <a:rPr lang="en-US" sz="1600" b="1" baseline="0">
                <a:solidFill>
                  <a:sysClr val="windowText" lastClr="000000"/>
                </a:solidFill>
              </a:rPr>
              <a:t> PATTERNS OF TE-LIKE CELLS' MARKERS</a:t>
            </a:r>
            <a:endParaRPr lang="en-US" sz="1600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5350290564133484"/>
          <c:y val="0.14824068906411242"/>
          <c:w val="0.830372597080554"/>
          <c:h val="0.73924672966445171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Figures!$K$15</c:f>
              <c:strCache>
                <c:ptCount val="1"/>
                <c:pt idx="0">
                  <c:v>CDX2/TROP2/TEAD4 negativ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Figures!$L$14:$O$14</c:f>
              <c:strCache>
                <c:ptCount val="4"/>
                <c:pt idx="0">
                  <c:v>Early HPAT21</c:v>
                </c:pt>
                <c:pt idx="1">
                  <c:v>Late HPAT21</c:v>
                </c:pt>
                <c:pt idx="2">
                  <c:v>Early HPAT21/HPAT15</c:v>
                </c:pt>
                <c:pt idx="3">
                  <c:v>Late HPAT21/HPAT15</c:v>
                </c:pt>
              </c:strCache>
            </c:strRef>
          </c:cat>
          <c:val>
            <c:numRef>
              <c:f>Figures!$L$15:$O$15</c:f>
              <c:numCache>
                <c:formatCode>0.0</c:formatCode>
                <c:ptCount val="4"/>
                <c:pt idx="0">
                  <c:v>72.727272727272734</c:v>
                </c:pt>
                <c:pt idx="1">
                  <c:v>38.983050847457626</c:v>
                </c:pt>
                <c:pt idx="2">
                  <c:v>88.888888888888886</c:v>
                </c:pt>
                <c:pt idx="3">
                  <c:v>77.192982456140342</c:v>
                </c:pt>
              </c:numCache>
            </c:numRef>
          </c:val>
        </c:ser>
        <c:ser>
          <c:idx val="1"/>
          <c:order val="1"/>
          <c:tx>
            <c:strRef>
              <c:f>Figures!$K$16</c:f>
              <c:strCache>
                <c:ptCount val="1"/>
                <c:pt idx="0">
                  <c:v>CDX2/TROP2/TEAD4 positive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  <a:sp3d>
              <a:contourClr>
                <a:srgbClr val="FF0000"/>
              </a:contourClr>
            </a:sp3d>
          </c:spPr>
          <c:invertIfNegative val="0"/>
          <c:cat>
            <c:strRef>
              <c:f>Figures!$L$14:$O$14</c:f>
              <c:strCache>
                <c:ptCount val="4"/>
                <c:pt idx="0">
                  <c:v>Early HPAT21</c:v>
                </c:pt>
                <c:pt idx="1">
                  <c:v>Late HPAT21</c:v>
                </c:pt>
                <c:pt idx="2">
                  <c:v>Early HPAT21/HPAT15</c:v>
                </c:pt>
                <c:pt idx="3">
                  <c:v>Late HPAT21/HPAT15</c:v>
                </c:pt>
              </c:strCache>
            </c:strRef>
          </c:cat>
          <c:val>
            <c:numRef>
              <c:f>Figures!$L$16:$O$16</c:f>
              <c:numCache>
                <c:formatCode>0.0</c:formatCode>
                <c:ptCount val="4"/>
                <c:pt idx="0">
                  <c:v>27.27272727272727</c:v>
                </c:pt>
                <c:pt idx="1">
                  <c:v>61.016949152542374</c:v>
                </c:pt>
                <c:pt idx="2">
                  <c:v>11.111111111111111</c:v>
                </c:pt>
                <c:pt idx="3">
                  <c:v>22.807017543859647</c:v>
                </c:pt>
              </c:numCache>
            </c:numRef>
          </c:val>
          <c:shape val="cylinder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65980576"/>
        <c:axId val="265985672"/>
        <c:axId val="0"/>
      </c:bar3DChart>
      <c:catAx>
        <c:axId val="265980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5672"/>
        <c:crosses val="autoZero"/>
        <c:auto val="1"/>
        <c:lblAlgn val="ctr"/>
        <c:lblOffset val="100"/>
        <c:noMultiLvlLbl val="0"/>
      </c:catAx>
      <c:valAx>
        <c:axId val="26598567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ysClr val="windowText" lastClr="000000"/>
                    </a:solidFill>
                  </a:rPr>
                  <a:t>PERCENT</a:t>
                </a:r>
                <a:r>
                  <a:rPr lang="en-US" sz="1600" b="1" baseline="0">
                    <a:solidFill>
                      <a:sysClr val="windowText" lastClr="000000"/>
                    </a:solidFill>
                  </a:rPr>
                  <a:t> OF POSITIVE CELLS</a:t>
                </a:r>
                <a:endParaRPr lang="en-US" sz="16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4.5048636654710456E-2"/>
              <c:y val="0.345106382302106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0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600" b="1">
                <a:solidFill>
                  <a:sysClr val="windowText" lastClr="000000"/>
                </a:solidFill>
              </a:rPr>
              <a:t>DIFFERENTIATION</a:t>
            </a:r>
            <a:r>
              <a:rPr lang="en-US" sz="1600" b="1" baseline="0">
                <a:solidFill>
                  <a:sysClr val="windowText" lastClr="000000"/>
                </a:solidFill>
              </a:rPr>
              <a:t> PATTERNS OF MARKERS OF PE-LIKE AND TE-LIKE CELLS</a:t>
            </a:r>
            <a:endParaRPr lang="en-US" sz="1600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2725667937389396"/>
          <c:y val="0.19637150566614353"/>
          <c:w val="0.85661882334799511"/>
          <c:h val="0.7035354764028614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Figures!$C$18</c:f>
              <c:strCache>
                <c:ptCount val="1"/>
                <c:pt idx="0">
                  <c:v>Early HPAT21/HPAT2/HPAT15 &amp; HPAT21/HPAT2;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Figures!$B$19:$B$22</c:f>
              <c:strCache>
                <c:ptCount val="4"/>
                <c:pt idx="0">
                  <c:v>FGFR2 (+)</c:v>
                </c:pt>
                <c:pt idx="1">
                  <c:v>GATA4 (+)</c:v>
                </c:pt>
                <c:pt idx="2">
                  <c:v>CDX2/TROP2/TEAD4 negative</c:v>
                </c:pt>
                <c:pt idx="3">
                  <c:v>CDX2/TROP2/TEAD4 positive</c:v>
                </c:pt>
              </c:strCache>
            </c:strRef>
          </c:cat>
          <c:val>
            <c:numRef>
              <c:f>Figures!$C$19:$C$22</c:f>
              <c:numCache>
                <c:formatCode>0.0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00</c:v>
                </c:pt>
              </c:numCache>
            </c:numRef>
          </c:val>
        </c:ser>
        <c:ser>
          <c:idx val="1"/>
          <c:order val="1"/>
          <c:tx>
            <c:strRef>
              <c:f>Figures!$D$18</c:f>
              <c:strCache>
                <c:ptCount val="1"/>
                <c:pt idx="0">
                  <c:v>Late HPAT21/HPAT2/HPAT15 &amp; HPAT21/HPAT2;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  <a:sp3d>
              <a:contourClr>
                <a:srgbClr val="FF0000"/>
              </a:contourClr>
            </a:sp3d>
          </c:spPr>
          <c:invertIfNegative val="0"/>
          <c:cat>
            <c:strRef>
              <c:f>Figures!$B$19:$B$22</c:f>
              <c:strCache>
                <c:ptCount val="4"/>
                <c:pt idx="0">
                  <c:v>FGFR2 (+)</c:v>
                </c:pt>
                <c:pt idx="1">
                  <c:v>GATA4 (+)</c:v>
                </c:pt>
                <c:pt idx="2">
                  <c:v>CDX2/TROP2/TEAD4 negative</c:v>
                </c:pt>
                <c:pt idx="3">
                  <c:v>CDX2/TROP2/TEAD4 positive</c:v>
                </c:pt>
              </c:strCache>
            </c:strRef>
          </c:cat>
          <c:val>
            <c:numRef>
              <c:f>Figures!$D$19:$D$22</c:f>
              <c:numCache>
                <c:formatCode>0.0</c:formatCode>
                <c:ptCount val="4"/>
                <c:pt idx="0">
                  <c:v>29.72972972972973</c:v>
                </c:pt>
                <c:pt idx="1">
                  <c:v>0</c:v>
                </c:pt>
                <c:pt idx="2">
                  <c:v>2.7</c:v>
                </c:pt>
                <c:pt idx="3">
                  <c:v>97.3</c:v>
                </c:pt>
              </c:numCache>
            </c:numRef>
          </c:val>
          <c:shape val="cylinder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65983320"/>
        <c:axId val="265986456"/>
        <c:axId val="0"/>
      </c:bar3DChart>
      <c:catAx>
        <c:axId val="265983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6456"/>
        <c:crosses val="autoZero"/>
        <c:auto val="1"/>
        <c:lblAlgn val="ctr"/>
        <c:lblOffset val="100"/>
        <c:noMultiLvlLbl val="0"/>
      </c:catAx>
      <c:valAx>
        <c:axId val="26598645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ysClr val="windowText" lastClr="000000"/>
                    </a:solidFill>
                  </a:rPr>
                  <a:t>PERCENT</a:t>
                </a:r>
                <a:r>
                  <a:rPr lang="en-US" sz="1600" b="1" baseline="0">
                    <a:solidFill>
                      <a:sysClr val="windowText" lastClr="000000"/>
                    </a:solidFill>
                  </a:rPr>
                  <a:t> OF POSITIVE CELLS</a:t>
                </a:r>
                <a:endParaRPr lang="en-US" sz="16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2.3031483975458445E-2"/>
              <c:y val="0.371955491317531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3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600" b="1">
                <a:solidFill>
                  <a:sysClr val="windowText" lastClr="000000"/>
                </a:solidFill>
              </a:rPr>
              <a:t>EXPRESSION</a:t>
            </a:r>
            <a:r>
              <a:rPr lang="en-US" sz="1600" b="1" baseline="0">
                <a:solidFill>
                  <a:sysClr val="windowText" lastClr="000000"/>
                </a:solidFill>
              </a:rPr>
              <a:t> PATTERNS OF LINEAGE-SPECIFIC MARKERS</a:t>
            </a:r>
            <a:endParaRPr lang="en-US" sz="1600" b="1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2139322581821724"/>
          <c:y val="0.14824068906411242"/>
          <c:w val="0.86248227690367174"/>
          <c:h val="0.77868506036625218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Figures!$J$1</c:f>
              <c:strCache>
                <c:ptCount val="1"/>
                <c:pt idx="0">
                  <c:v>HPAT21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Figures!$I$2:$I$12</c:f>
              <c:strCache>
                <c:ptCount val="11"/>
                <c:pt idx="0">
                  <c:v>TROP2</c:v>
                </c:pt>
                <c:pt idx="1">
                  <c:v>TEAD4</c:v>
                </c:pt>
                <c:pt idx="2">
                  <c:v>CDX2</c:v>
                </c:pt>
                <c:pt idx="3">
                  <c:v>PDGFRa</c:v>
                </c:pt>
                <c:pt idx="4">
                  <c:v>CXCR4</c:v>
                </c:pt>
                <c:pt idx="5">
                  <c:v>GATA4</c:v>
                </c:pt>
                <c:pt idx="6">
                  <c:v>GRB2</c:v>
                </c:pt>
                <c:pt idx="7">
                  <c:v>TDGF1</c:v>
                </c:pt>
                <c:pt idx="8">
                  <c:v>SOX2</c:v>
                </c:pt>
                <c:pt idx="9">
                  <c:v>LIN28A</c:v>
                </c:pt>
                <c:pt idx="10">
                  <c:v>HPAT15</c:v>
                </c:pt>
              </c:strCache>
            </c:strRef>
          </c:cat>
          <c:val>
            <c:numRef>
              <c:f>Figures!$J$2:$J$12</c:f>
              <c:numCache>
                <c:formatCode>0.0</c:formatCode>
                <c:ptCount val="11"/>
                <c:pt idx="0">
                  <c:v>33.898305084745758</c:v>
                </c:pt>
                <c:pt idx="1">
                  <c:v>38.983050847457626</c:v>
                </c:pt>
                <c:pt idx="2">
                  <c:v>15.254237288135593</c:v>
                </c:pt>
                <c:pt idx="3">
                  <c:v>13.559322033898304</c:v>
                </c:pt>
                <c:pt idx="4">
                  <c:v>22.033898305084744</c:v>
                </c:pt>
                <c:pt idx="5">
                  <c:v>5.0847457627118651</c:v>
                </c:pt>
                <c:pt idx="6">
                  <c:v>5.0847457627118651</c:v>
                </c:pt>
                <c:pt idx="7">
                  <c:v>22.033898305084744</c:v>
                </c:pt>
                <c:pt idx="8">
                  <c:v>35.593220338983052</c:v>
                </c:pt>
                <c:pt idx="9">
                  <c:v>47.457627118644069</c:v>
                </c:pt>
                <c:pt idx="10">
                  <c:v>0</c:v>
                </c:pt>
              </c:numCache>
            </c:numRef>
          </c:val>
          <c:shape val="pyramidToMax"/>
        </c:ser>
        <c:ser>
          <c:idx val="1"/>
          <c:order val="1"/>
          <c:tx>
            <c:strRef>
              <c:f>Figures!$K$1</c:f>
              <c:strCache>
                <c:ptCount val="1"/>
                <c:pt idx="0">
                  <c:v>HPAT21/HPAT15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  <a:sp3d>
              <a:contourClr>
                <a:srgbClr val="FF0000"/>
              </a:contourClr>
            </a:sp3d>
          </c:spPr>
          <c:invertIfNegative val="0"/>
          <c:cat>
            <c:strRef>
              <c:f>Figures!$I$2:$I$12</c:f>
              <c:strCache>
                <c:ptCount val="11"/>
                <c:pt idx="0">
                  <c:v>TROP2</c:v>
                </c:pt>
                <c:pt idx="1">
                  <c:v>TEAD4</c:v>
                </c:pt>
                <c:pt idx="2">
                  <c:v>CDX2</c:v>
                </c:pt>
                <c:pt idx="3">
                  <c:v>PDGFRa</c:v>
                </c:pt>
                <c:pt idx="4">
                  <c:v>CXCR4</c:v>
                </c:pt>
                <c:pt idx="5">
                  <c:v>GATA4</c:v>
                </c:pt>
                <c:pt idx="6">
                  <c:v>GRB2</c:v>
                </c:pt>
                <c:pt idx="7">
                  <c:v>TDGF1</c:v>
                </c:pt>
                <c:pt idx="8">
                  <c:v>SOX2</c:v>
                </c:pt>
                <c:pt idx="9">
                  <c:v>LIN28A</c:v>
                </c:pt>
                <c:pt idx="10">
                  <c:v>HPAT15</c:v>
                </c:pt>
              </c:strCache>
            </c:strRef>
          </c:cat>
          <c:val>
            <c:numRef>
              <c:f>Figures!$K$2:$K$12</c:f>
              <c:numCache>
                <c:formatCode>0.0</c:formatCode>
                <c:ptCount val="11"/>
                <c:pt idx="0">
                  <c:v>21.052631578947366</c:v>
                </c:pt>
                <c:pt idx="1">
                  <c:v>10.526315789473683</c:v>
                </c:pt>
                <c:pt idx="2">
                  <c:v>12.280701754385964</c:v>
                </c:pt>
                <c:pt idx="3">
                  <c:v>8.7719298245614024</c:v>
                </c:pt>
                <c:pt idx="4">
                  <c:v>17.543859649122805</c:v>
                </c:pt>
                <c:pt idx="5">
                  <c:v>45.614035087719294</c:v>
                </c:pt>
                <c:pt idx="6">
                  <c:v>1.7543859649122806</c:v>
                </c:pt>
                <c:pt idx="7">
                  <c:v>5.2631578947368416</c:v>
                </c:pt>
                <c:pt idx="8">
                  <c:v>28.07017543859649</c:v>
                </c:pt>
                <c:pt idx="9">
                  <c:v>47.368421052631575</c:v>
                </c:pt>
                <c:pt idx="10">
                  <c:v>100</c:v>
                </c:pt>
              </c:numCache>
            </c:numRef>
          </c:val>
          <c:shape val="cylinder"/>
        </c:ser>
        <c:ser>
          <c:idx val="2"/>
          <c:order val="2"/>
          <c:tx>
            <c:strRef>
              <c:f>Figures!$L$1</c:f>
              <c:strCache>
                <c:ptCount val="1"/>
                <c:pt idx="0">
                  <c:v>HPAT21/HPAT2/HPAT15 &amp; HPAT21/HPAT2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  <a:sp3d>
              <a:contourClr>
                <a:srgbClr val="0070C0"/>
              </a:contourClr>
            </a:sp3d>
          </c:spPr>
          <c:invertIfNegative val="0"/>
          <c:cat>
            <c:strRef>
              <c:f>Figures!$I$2:$I$12</c:f>
              <c:strCache>
                <c:ptCount val="11"/>
                <c:pt idx="0">
                  <c:v>TROP2</c:v>
                </c:pt>
                <c:pt idx="1">
                  <c:v>TEAD4</c:v>
                </c:pt>
                <c:pt idx="2">
                  <c:v>CDX2</c:v>
                </c:pt>
                <c:pt idx="3">
                  <c:v>PDGFRa</c:v>
                </c:pt>
                <c:pt idx="4">
                  <c:v>CXCR4</c:v>
                </c:pt>
                <c:pt idx="5">
                  <c:v>GATA4</c:v>
                </c:pt>
                <c:pt idx="6">
                  <c:v>GRB2</c:v>
                </c:pt>
                <c:pt idx="7">
                  <c:v>TDGF1</c:v>
                </c:pt>
                <c:pt idx="8">
                  <c:v>SOX2</c:v>
                </c:pt>
                <c:pt idx="9">
                  <c:v>LIN28A</c:v>
                </c:pt>
                <c:pt idx="10">
                  <c:v>HPAT15</c:v>
                </c:pt>
              </c:strCache>
            </c:strRef>
          </c:cat>
          <c:val>
            <c:numRef>
              <c:f>Figures!$L$2:$L$12</c:f>
              <c:numCache>
                <c:formatCode>0.0</c:formatCode>
                <c:ptCount val="11"/>
                <c:pt idx="0">
                  <c:v>75.675675675675677</c:v>
                </c:pt>
                <c:pt idx="1">
                  <c:v>75.675675675675677</c:v>
                </c:pt>
                <c:pt idx="2">
                  <c:v>81.081081081081081</c:v>
                </c:pt>
                <c:pt idx="3">
                  <c:v>2.7027027027027026</c:v>
                </c:pt>
                <c:pt idx="4">
                  <c:v>59.45945945945946</c:v>
                </c:pt>
                <c:pt idx="5">
                  <c:v>0</c:v>
                </c:pt>
                <c:pt idx="6">
                  <c:v>27.027027027027028</c:v>
                </c:pt>
                <c:pt idx="7">
                  <c:v>64.86486486486487</c:v>
                </c:pt>
                <c:pt idx="8">
                  <c:v>86.486486486486484</c:v>
                </c:pt>
                <c:pt idx="9">
                  <c:v>91.891891891891902</c:v>
                </c:pt>
                <c:pt idx="10">
                  <c:v>43.2432432432432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65981752"/>
        <c:axId val="265982536"/>
        <c:axId val="0"/>
      </c:bar3DChart>
      <c:catAx>
        <c:axId val="265981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2536"/>
        <c:crosses val="autoZero"/>
        <c:auto val="1"/>
        <c:lblAlgn val="ctr"/>
        <c:lblOffset val="100"/>
        <c:noMultiLvlLbl val="0"/>
      </c:catAx>
      <c:valAx>
        <c:axId val="26598253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ysClr val="windowText" lastClr="000000"/>
                    </a:solidFill>
                  </a:rPr>
                  <a:t>PERCENT</a:t>
                </a:r>
                <a:r>
                  <a:rPr lang="en-US" sz="1600" b="1" baseline="0">
                    <a:solidFill>
                      <a:sysClr val="windowText" lastClr="000000"/>
                    </a:solidFill>
                  </a:rPr>
                  <a:t> OF POSITIVE CELLS</a:t>
                </a:r>
                <a:endParaRPr lang="en-US" sz="16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1.6019578394604883E-2"/>
              <c:y val="0.34992598316772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17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dirty="0">
                <a:solidFill>
                  <a:sysClr val="windowText" lastClr="000000"/>
                </a:solidFill>
              </a:rPr>
              <a:t>HPATs</a:t>
            </a:r>
            <a:r>
              <a:rPr lang="en-US" sz="1800" b="1" baseline="0" dirty="0">
                <a:solidFill>
                  <a:sysClr val="windowText" lastClr="000000"/>
                </a:solidFill>
              </a:rPr>
              <a:t> Expression Patterns in </a:t>
            </a:r>
            <a:r>
              <a:rPr lang="en-US" sz="1800" b="1" baseline="0" dirty="0" smtClean="0">
                <a:solidFill>
                  <a:sysClr val="windowText" lastClr="000000"/>
                </a:solidFill>
              </a:rPr>
              <a:t>241 Blastocyst </a:t>
            </a:r>
            <a:r>
              <a:rPr lang="en-US" sz="1800" b="1" baseline="0" dirty="0">
                <a:solidFill>
                  <a:sysClr val="windowText" lastClr="000000"/>
                </a:solidFill>
              </a:rPr>
              <a:t>Cells of Human Embryos</a:t>
            </a:r>
            <a:endParaRPr lang="en-US" sz="1800" b="1" dirty="0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radarChart>
        <c:radarStyle val="marker"/>
        <c:varyColors val="0"/>
        <c:ser>
          <c:idx val="0"/>
          <c:order val="0"/>
          <c:tx>
            <c:strRef>
              <c:f>Sheet1!$D$1</c:f>
              <c:strCache>
                <c:ptCount val="1"/>
                <c:pt idx="0">
                  <c:v>HPAT2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Sheet1!$D$2:$D$242</c:f>
              <c:numCache>
                <c:formatCode>General</c:formatCode>
                <c:ptCount val="241"/>
                <c:pt idx="0">
                  <c:v>11.99873328</c:v>
                </c:pt>
                <c:pt idx="1">
                  <c:v>12.09656665</c:v>
                </c:pt>
                <c:pt idx="2">
                  <c:v>10.13427742</c:v>
                </c:pt>
                <c:pt idx="3">
                  <c:v>5.7545995220000004</c:v>
                </c:pt>
                <c:pt idx="4">
                  <c:v>5.2873062040000001</c:v>
                </c:pt>
                <c:pt idx="5">
                  <c:v>9.5741062479999997</c:v>
                </c:pt>
                <c:pt idx="6">
                  <c:v>11.191305699999999</c:v>
                </c:pt>
                <c:pt idx="7">
                  <c:v>9.4413358800000005</c:v>
                </c:pt>
                <c:pt idx="8">
                  <c:v>10.97115032</c:v>
                </c:pt>
                <c:pt idx="9">
                  <c:v>7.7423445859999998</c:v>
                </c:pt>
                <c:pt idx="10">
                  <c:v>11.50356021</c:v>
                </c:pt>
                <c:pt idx="11">
                  <c:v>11.41893282</c:v>
                </c:pt>
                <c:pt idx="12">
                  <c:v>8.3299059379999996</c:v>
                </c:pt>
                <c:pt idx="13">
                  <c:v>11.14788624</c:v>
                </c:pt>
                <c:pt idx="14">
                  <c:v>11.04963373</c:v>
                </c:pt>
                <c:pt idx="15">
                  <c:v>10.278764730000001</c:v>
                </c:pt>
                <c:pt idx="16">
                  <c:v>5.315456706</c:v>
                </c:pt>
                <c:pt idx="17">
                  <c:v>11.5565427</c:v>
                </c:pt>
                <c:pt idx="18">
                  <c:v>9.6389264959999998</c:v>
                </c:pt>
                <c:pt idx="19">
                  <c:v>9.0586594320000007</c:v>
                </c:pt>
                <c:pt idx="20">
                  <c:v>9.2414128519999998</c:v>
                </c:pt>
                <c:pt idx="21">
                  <c:v>7.1095627280000002</c:v>
                </c:pt>
                <c:pt idx="22">
                  <c:v>12.48149197</c:v>
                </c:pt>
                <c:pt idx="23">
                  <c:v>11.61118426</c:v>
                </c:pt>
                <c:pt idx="24">
                  <c:v>10.645449599999999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9.558829867</c:v>
                </c:pt>
                <c:pt idx="32">
                  <c:v>11.419728510000001</c:v>
                </c:pt>
                <c:pt idx="33">
                  <c:v>12.59500261</c:v>
                </c:pt>
                <c:pt idx="34">
                  <c:v>8.8265643209999993</c:v>
                </c:pt>
                <c:pt idx="35">
                  <c:v>9.2752559699999999</c:v>
                </c:pt>
                <c:pt idx="36">
                  <c:v>11.86805801</c:v>
                </c:pt>
                <c:pt idx="37">
                  <c:v>6.9712677320000003</c:v>
                </c:pt>
                <c:pt idx="38">
                  <c:v>9.092474245</c:v>
                </c:pt>
                <c:pt idx="39">
                  <c:v>8.9943366400000002</c:v>
                </c:pt>
                <c:pt idx="40">
                  <c:v>12.529868909999999</c:v>
                </c:pt>
                <c:pt idx="41">
                  <c:v>14.033336050000001</c:v>
                </c:pt>
                <c:pt idx="42">
                  <c:v>13.276352060000001</c:v>
                </c:pt>
                <c:pt idx="43">
                  <c:v>11.63699366</c:v>
                </c:pt>
                <c:pt idx="44">
                  <c:v>10.075975120000001</c:v>
                </c:pt>
                <c:pt idx="45">
                  <c:v>7.7950492029999996</c:v>
                </c:pt>
                <c:pt idx="46">
                  <c:v>8.8695645110000001</c:v>
                </c:pt>
                <c:pt idx="47">
                  <c:v>10.090433190000001</c:v>
                </c:pt>
                <c:pt idx="48">
                  <c:v>9.7654756549999995</c:v>
                </c:pt>
                <c:pt idx="49">
                  <c:v>11.228448350000001</c:v>
                </c:pt>
                <c:pt idx="50">
                  <c:v>12.10672969</c:v>
                </c:pt>
                <c:pt idx="51">
                  <c:v>12.946798920000001</c:v>
                </c:pt>
                <c:pt idx="52">
                  <c:v>9.8251244930000006</c:v>
                </c:pt>
                <c:pt idx="53">
                  <c:v>8.9613813580000006</c:v>
                </c:pt>
                <c:pt idx="54">
                  <c:v>13.85670767</c:v>
                </c:pt>
                <c:pt idx="55">
                  <c:v>12.60755625</c:v>
                </c:pt>
                <c:pt idx="56">
                  <c:v>9.2933112040000001</c:v>
                </c:pt>
                <c:pt idx="57">
                  <c:v>9.6009175689999999</c:v>
                </c:pt>
                <c:pt idx="58">
                  <c:v>12.579351559999999</c:v>
                </c:pt>
                <c:pt idx="59">
                  <c:v>13.5442982</c:v>
                </c:pt>
                <c:pt idx="60">
                  <c:v>11.628524669999999</c:v>
                </c:pt>
                <c:pt idx="61">
                  <c:v>10.9684515</c:v>
                </c:pt>
                <c:pt idx="62">
                  <c:v>9.906762252</c:v>
                </c:pt>
                <c:pt idx="63">
                  <c:v>13.149525580000001</c:v>
                </c:pt>
                <c:pt idx="64">
                  <c:v>10.30622556</c:v>
                </c:pt>
                <c:pt idx="65">
                  <c:v>8.7947638690000005</c:v>
                </c:pt>
                <c:pt idx="66">
                  <c:v>12.062914320000001</c:v>
                </c:pt>
                <c:pt idx="67">
                  <c:v>10.463341079999999</c:v>
                </c:pt>
                <c:pt idx="68">
                  <c:v>14.298528279999999</c:v>
                </c:pt>
                <c:pt idx="69">
                  <c:v>9.5730352609999994</c:v>
                </c:pt>
                <c:pt idx="70">
                  <c:v>12.783326990000001</c:v>
                </c:pt>
                <c:pt idx="71">
                  <c:v>12.246702170000001</c:v>
                </c:pt>
                <c:pt idx="72">
                  <c:v>9.8184804470000007</c:v>
                </c:pt>
                <c:pt idx="73">
                  <c:v>11.740371740000001</c:v>
                </c:pt>
                <c:pt idx="74">
                  <c:v>10.047336899999999</c:v>
                </c:pt>
                <c:pt idx="75">
                  <c:v>10.64002268</c:v>
                </c:pt>
                <c:pt idx="76">
                  <c:v>12.279840780000001</c:v>
                </c:pt>
                <c:pt idx="77">
                  <c:v>12.04419204</c:v>
                </c:pt>
                <c:pt idx="78">
                  <c:v>13.29778217</c:v>
                </c:pt>
                <c:pt idx="79">
                  <c:v>10.20815657</c:v>
                </c:pt>
                <c:pt idx="80">
                  <c:v>8.8188217630000008</c:v>
                </c:pt>
                <c:pt idx="81">
                  <c:v>13.81619759</c:v>
                </c:pt>
                <c:pt idx="82">
                  <c:v>11.579533830000001</c:v>
                </c:pt>
                <c:pt idx="83">
                  <c:v>12.546473130000001</c:v>
                </c:pt>
                <c:pt idx="84">
                  <c:v>13.59995793</c:v>
                </c:pt>
                <c:pt idx="85">
                  <c:v>12.89354855</c:v>
                </c:pt>
                <c:pt idx="86">
                  <c:v>10.875782429999999</c:v>
                </c:pt>
                <c:pt idx="87">
                  <c:v>13.53578914</c:v>
                </c:pt>
                <c:pt idx="88">
                  <c:v>9.0330645040000004</c:v>
                </c:pt>
                <c:pt idx="89">
                  <c:v>9.2452232379999995</c:v>
                </c:pt>
                <c:pt idx="90">
                  <c:v>9.2604894580000003</c:v>
                </c:pt>
                <c:pt idx="91">
                  <c:v>9.9070771519999994</c:v>
                </c:pt>
                <c:pt idx="92">
                  <c:v>8.521000634</c:v>
                </c:pt>
                <c:pt idx="93">
                  <c:v>8.4581842149999993</c:v>
                </c:pt>
                <c:pt idx="94">
                  <c:v>9.4746934409999994</c:v>
                </c:pt>
                <c:pt idx="95">
                  <c:v>9.8537901229999996</c:v>
                </c:pt>
                <c:pt idx="96">
                  <c:v>9.0151419330000007</c:v>
                </c:pt>
                <c:pt idx="97">
                  <c:v>9.5186147420000005</c:v>
                </c:pt>
                <c:pt idx="98">
                  <c:v>6.7153747399999997</c:v>
                </c:pt>
                <c:pt idx="99">
                  <c:v>7.3983567470000002</c:v>
                </c:pt>
                <c:pt idx="100">
                  <c:v>6.8419123949999996</c:v>
                </c:pt>
                <c:pt idx="101">
                  <c:v>9.1059359400000002</c:v>
                </c:pt>
                <c:pt idx="102">
                  <c:v>11.41001146</c:v>
                </c:pt>
                <c:pt idx="103">
                  <c:v>11.96716417</c:v>
                </c:pt>
                <c:pt idx="104">
                  <c:v>9.6308498020000002</c:v>
                </c:pt>
                <c:pt idx="105">
                  <c:v>10.02052555</c:v>
                </c:pt>
                <c:pt idx="106">
                  <c:v>7.7943884399999996</c:v>
                </c:pt>
                <c:pt idx="107">
                  <c:v>9.2745528559999997</c:v>
                </c:pt>
                <c:pt idx="108">
                  <c:v>7.6357183449999999</c:v>
                </c:pt>
                <c:pt idx="109">
                  <c:v>4.6151159770000003</c:v>
                </c:pt>
                <c:pt idx="110">
                  <c:v>11.245972699999999</c:v>
                </c:pt>
                <c:pt idx="111">
                  <c:v>3.6535841269999998</c:v>
                </c:pt>
                <c:pt idx="112">
                  <c:v>11.492176430000001</c:v>
                </c:pt>
                <c:pt idx="113">
                  <c:v>7.6784977359999997</c:v>
                </c:pt>
                <c:pt idx="114">
                  <c:v>8.7513392959999994</c:v>
                </c:pt>
                <c:pt idx="115">
                  <c:v>8.2399293710000006</c:v>
                </c:pt>
                <c:pt idx="116">
                  <c:v>7.8421158889999996</c:v>
                </c:pt>
                <c:pt idx="117">
                  <c:v>9.320875354</c:v>
                </c:pt>
                <c:pt idx="118">
                  <c:v>9.5174813070000006</c:v>
                </c:pt>
                <c:pt idx="119">
                  <c:v>9.9499931939999993</c:v>
                </c:pt>
                <c:pt idx="120">
                  <c:v>9.7179215879999994</c:v>
                </c:pt>
                <c:pt idx="121">
                  <c:v>9.3960813759999997</c:v>
                </c:pt>
                <c:pt idx="122">
                  <c:v>9.9017408870000008</c:v>
                </c:pt>
                <c:pt idx="123">
                  <c:v>8.9861219460000008</c:v>
                </c:pt>
                <c:pt idx="124">
                  <c:v>9.4770085739999992</c:v>
                </c:pt>
                <c:pt idx="125">
                  <c:v>8.7636199809999997</c:v>
                </c:pt>
                <c:pt idx="126">
                  <c:v>10.03357658</c:v>
                </c:pt>
                <c:pt idx="127">
                  <c:v>8.0073399260000002</c:v>
                </c:pt>
                <c:pt idx="128">
                  <c:v>9.3717993340000003</c:v>
                </c:pt>
                <c:pt idx="129">
                  <c:v>10.24437818</c:v>
                </c:pt>
                <c:pt idx="130">
                  <c:v>7.324374079</c:v>
                </c:pt>
                <c:pt idx="131">
                  <c:v>9.0150677829999992</c:v>
                </c:pt>
                <c:pt idx="132">
                  <c:v>9.5703522779999997</c:v>
                </c:pt>
                <c:pt idx="133">
                  <c:v>9.6221092049999992</c:v>
                </c:pt>
                <c:pt idx="134">
                  <c:v>9.2542914399999994</c:v>
                </c:pt>
                <c:pt idx="135">
                  <c:v>10.18147076</c:v>
                </c:pt>
                <c:pt idx="136">
                  <c:v>11.470322899999999</c:v>
                </c:pt>
                <c:pt idx="137">
                  <c:v>10.304745670000001</c:v>
                </c:pt>
                <c:pt idx="138">
                  <c:v>9.1870411440000002</c:v>
                </c:pt>
                <c:pt idx="139">
                  <c:v>10.838005920000001</c:v>
                </c:pt>
                <c:pt idx="140">
                  <c:v>7.0548333789999997</c:v>
                </c:pt>
                <c:pt idx="141">
                  <c:v>12.92020327</c:v>
                </c:pt>
                <c:pt idx="142">
                  <c:v>9.9930027389999996</c:v>
                </c:pt>
                <c:pt idx="143">
                  <c:v>10.82369712</c:v>
                </c:pt>
                <c:pt idx="144">
                  <c:v>9.0384907709999993</c:v>
                </c:pt>
                <c:pt idx="145">
                  <c:v>9.1778097340000002</c:v>
                </c:pt>
                <c:pt idx="146">
                  <c:v>8.7879346379999994</c:v>
                </c:pt>
                <c:pt idx="147">
                  <c:v>10.254375550000001</c:v>
                </c:pt>
                <c:pt idx="148">
                  <c:v>3.0057328980000002</c:v>
                </c:pt>
                <c:pt idx="149">
                  <c:v>13.422421290000001</c:v>
                </c:pt>
                <c:pt idx="150">
                  <c:v>8.7994767770000006</c:v>
                </c:pt>
                <c:pt idx="151">
                  <c:v>13.874650340000001</c:v>
                </c:pt>
                <c:pt idx="152">
                  <c:v>8.6742953909999994</c:v>
                </c:pt>
                <c:pt idx="153">
                  <c:v>8.7303543579999996</c:v>
                </c:pt>
                <c:pt idx="154">
                  <c:v>9.0835642389999993</c:v>
                </c:pt>
                <c:pt idx="155">
                  <c:v>12.383625990000001</c:v>
                </c:pt>
                <c:pt idx="156">
                  <c:v>8.5247452490000004</c:v>
                </c:pt>
                <c:pt idx="157">
                  <c:v>5.8660914980000003</c:v>
                </c:pt>
                <c:pt idx="158">
                  <c:v>11.50230284</c:v>
                </c:pt>
                <c:pt idx="159">
                  <c:v>10.405437040000001</c:v>
                </c:pt>
                <c:pt idx="160">
                  <c:v>10.121867590000001</c:v>
                </c:pt>
                <c:pt idx="161">
                  <c:v>8.7648517049999999</c:v>
                </c:pt>
                <c:pt idx="162">
                  <c:v>9.7256319449999999</c:v>
                </c:pt>
                <c:pt idx="163">
                  <c:v>8.5222880659999998</c:v>
                </c:pt>
                <c:pt idx="164">
                  <c:v>14.14588307</c:v>
                </c:pt>
                <c:pt idx="165">
                  <c:v>8.9349455259999999</c:v>
                </c:pt>
                <c:pt idx="166">
                  <c:v>11.89505561</c:v>
                </c:pt>
                <c:pt idx="167">
                  <c:v>7.5699177259999999</c:v>
                </c:pt>
                <c:pt idx="168">
                  <c:v>15.1767082</c:v>
                </c:pt>
                <c:pt idx="169">
                  <c:v>13.382433669999999</c:v>
                </c:pt>
                <c:pt idx="170">
                  <c:v>9.2357632029999994</c:v>
                </c:pt>
                <c:pt idx="171">
                  <c:v>14.314837259999999</c:v>
                </c:pt>
                <c:pt idx="172">
                  <c:v>8.9836593419999993</c:v>
                </c:pt>
                <c:pt idx="173">
                  <c:v>13.73097211</c:v>
                </c:pt>
                <c:pt idx="174">
                  <c:v>8.6599420560000002</c:v>
                </c:pt>
                <c:pt idx="175">
                  <c:v>15.15021438</c:v>
                </c:pt>
                <c:pt idx="176">
                  <c:v>11.2064789</c:v>
                </c:pt>
                <c:pt idx="177">
                  <c:v>12.4402782</c:v>
                </c:pt>
                <c:pt idx="178">
                  <c:v>10.823246210000001</c:v>
                </c:pt>
                <c:pt idx="179">
                  <c:v>13.83920966</c:v>
                </c:pt>
                <c:pt idx="180">
                  <c:v>13.49463211</c:v>
                </c:pt>
                <c:pt idx="181">
                  <c:v>16.087255899999999</c:v>
                </c:pt>
                <c:pt idx="182">
                  <c:v>8.5814796829999995</c:v>
                </c:pt>
                <c:pt idx="183">
                  <c:v>11.66762662</c:v>
                </c:pt>
                <c:pt idx="184">
                  <c:v>13.951573939999999</c:v>
                </c:pt>
                <c:pt idx="185">
                  <c:v>12.05683786</c:v>
                </c:pt>
                <c:pt idx="186">
                  <c:v>10.6800382</c:v>
                </c:pt>
                <c:pt idx="187">
                  <c:v>9.1448827070000007</c:v>
                </c:pt>
                <c:pt idx="188">
                  <c:v>9.2675851429999998</c:v>
                </c:pt>
                <c:pt idx="189">
                  <c:v>11.01545707</c:v>
                </c:pt>
                <c:pt idx="190">
                  <c:v>7.9953558180000002</c:v>
                </c:pt>
                <c:pt idx="191">
                  <c:v>8.8651370939999996</c:v>
                </c:pt>
                <c:pt idx="192">
                  <c:v>9.6499371390000004</c:v>
                </c:pt>
                <c:pt idx="193">
                  <c:v>8.224094333</c:v>
                </c:pt>
                <c:pt idx="194">
                  <c:v>9.4934328420000007</c:v>
                </c:pt>
                <c:pt idx="195">
                  <c:v>8.2568802899999998</c:v>
                </c:pt>
                <c:pt idx="196">
                  <c:v>13.49369866</c:v>
                </c:pt>
                <c:pt idx="197">
                  <c:v>9.6881992550000007</c:v>
                </c:pt>
                <c:pt idx="198">
                  <c:v>8.994670352</c:v>
                </c:pt>
                <c:pt idx="199">
                  <c:v>10.693199890000001</c:v>
                </c:pt>
                <c:pt idx="200">
                  <c:v>8.7137384359999999</c:v>
                </c:pt>
                <c:pt idx="201">
                  <c:v>11.452228180000001</c:v>
                </c:pt>
                <c:pt idx="202">
                  <c:v>11.5651113</c:v>
                </c:pt>
                <c:pt idx="203">
                  <c:v>9.1383961320000004</c:v>
                </c:pt>
                <c:pt idx="204">
                  <c:v>8.8386195910000005</c:v>
                </c:pt>
                <c:pt idx="205">
                  <c:v>9.3409282499999993</c:v>
                </c:pt>
                <c:pt idx="206">
                  <c:v>9.7540076550000006</c:v>
                </c:pt>
                <c:pt idx="207">
                  <c:v>12.059088170000001</c:v>
                </c:pt>
                <c:pt idx="208">
                  <c:v>9.2657596410000007</c:v>
                </c:pt>
                <c:pt idx="209">
                  <c:v>13.055139499999999</c:v>
                </c:pt>
                <c:pt idx="210">
                  <c:v>11.97987575</c:v>
                </c:pt>
                <c:pt idx="211">
                  <c:v>10.76630201</c:v>
                </c:pt>
                <c:pt idx="212">
                  <c:v>9.3522181389999997</c:v>
                </c:pt>
                <c:pt idx="213">
                  <c:v>11.331466949999999</c:v>
                </c:pt>
                <c:pt idx="214">
                  <c:v>8.9663466290000002</c:v>
                </c:pt>
                <c:pt idx="215">
                  <c:v>8.8485732939999995</c:v>
                </c:pt>
                <c:pt idx="216">
                  <c:v>9.2245337559999996</c:v>
                </c:pt>
                <c:pt idx="217">
                  <c:v>8.7657777419999992</c:v>
                </c:pt>
                <c:pt idx="218">
                  <c:v>9.3253948900000001</c:v>
                </c:pt>
                <c:pt idx="219">
                  <c:v>8.8393793630000008</c:v>
                </c:pt>
                <c:pt idx="220">
                  <c:v>11.31452889</c:v>
                </c:pt>
                <c:pt idx="221">
                  <c:v>9.4367379079999996</c:v>
                </c:pt>
                <c:pt idx="222">
                  <c:v>9.6909964290000001</c:v>
                </c:pt>
                <c:pt idx="223">
                  <c:v>10.079952349999999</c:v>
                </c:pt>
                <c:pt idx="224">
                  <c:v>11.17803099</c:v>
                </c:pt>
                <c:pt idx="225">
                  <c:v>11.443634749999999</c:v>
                </c:pt>
                <c:pt idx="226">
                  <c:v>9.5549889750000006</c:v>
                </c:pt>
                <c:pt idx="227">
                  <c:v>0</c:v>
                </c:pt>
                <c:pt idx="228">
                  <c:v>9.8327566110000006</c:v>
                </c:pt>
                <c:pt idx="229">
                  <c:v>9.9776251029999994</c:v>
                </c:pt>
                <c:pt idx="230">
                  <c:v>9.3359428690000001</c:v>
                </c:pt>
                <c:pt idx="231">
                  <c:v>12.987317770000001</c:v>
                </c:pt>
                <c:pt idx="232">
                  <c:v>8.9306590610000001</c:v>
                </c:pt>
                <c:pt idx="233">
                  <c:v>8.3854919599999995</c:v>
                </c:pt>
                <c:pt idx="234">
                  <c:v>9.0432355609999995</c:v>
                </c:pt>
                <c:pt idx="235">
                  <c:v>8.6321694400000002</c:v>
                </c:pt>
                <c:pt idx="236">
                  <c:v>8.5734262290000007</c:v>
                </c:pt>
                <c:pt idx="237">
                  <c:v>10.929428059999999</c:v>
                </c:pt>
                <c:pt idx="238">
                  <c:v>11.44340375</c:v>
                </c:pt>
                <c:pt idx="239">
                  <c:v>11.509520220000001</c:v>
                </c:pt>
                <c:pt idx="240">
                  <c:v>11.49715307</c:v>
                </c:pt>
              </c:numCache>
            </c:numRef>
          </c:val>
        </c:ser>
        <c:ser>
          <c:idx val="1"/>
          <c:order val="1"/>
          <c:tx>
            <c:strRef>
              <c:f>Sheet1!$E$1</c:f>
              <c:strCache>
                <c:ptCount val="1"/>
                <c:pt idx="0">
                  <c:v>HPAT15</c:v>
                </c:pt>
              </c:strCache>
            </c:strRef>
          </c:tx>
          <c:spPr>
            <a:ln w="317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Sheet1!$E$2:$E$242</c:f>
              <c:numCache>
                <c:formatCode>General</c:formatCode>
                <c:ptCount val="241"/>
                <c:pt idx="0">
                  <c:v>6.9996444860000002</c:v>
                </c:pt>
                <c:pt idx="1">
                  <c:v>9.8138476430000008</c:v>
                </c:pt>
                <c:pt idx="2">
                  <c:v>2.3446043009999999</c:v>
                </c:pt>
                <c:pt idx="3">
                  <c:v>3.3524538100000001</c:v>
                </c:pt>
                <c:pt idx="4">
                  <c:v>4.0931578569999996</c:v>
                </c:pt>
                <c:pt idx="5">
                  <c:v>4.4251827239999999</c:v>
                </c:pt>
                <c:pt idx="6">
                  <c:v>8.6669600990000006</c:v>
                </c:pt>
                <c:pt idx="7">
                  <c:v>5.1696126250000001</c:v>
                </c:pt>
                <c:pt idx="8">
                  <c:v>4.320395435</c:v>
                </c:pt>
                <c:pt idx="9">
                  <c:v>3.5046871369999999</c:v>
                </c:pt>
                <c:pt idx="10">
                  <c:v>8.2352069970000006</c:v>
                </c:pt>
                <c:pt idx="11">
                  <c:v>6.9996444860000002</c:v>
                </c:pt>
                <c:pt idx="12">
                  <c:v>6.2256769739999998</c:v>
                </c:pt>
                <c:pt idx="13">
                  <c:v>3.6770208360000001</c:v>
                </c:pt>
                <c:pt idx="14">
                  <c:v>8.7807667550000001</c:v>
                </c:pt>
                <c:pt idx="15">
                  <c:v>7.7136675930000003</c:v>
                </c:pt>
                <c:pt idx="16">
                  <c:v>2.8077451180000002</c:v>
                </c:pt>
                <c:pt idx="17">
                  <c:v>6.9996444860000002</c:v>
                </c:pt>
                <c:pt idx="18">
                  <c:v>4.8747249200000002</c:v>
                </c:pt>
                <c:pt idx="19">
                  <c:v>6.6067635090000003</c:v>
                </c:pt>
                <c:pt idx="20">
                  <c:v>6.0686000870000001</c:v>
                </c:pt>
                <c:pt idx="21">
                  <c:v>3.3608375960000001</c:v>
                </c:pt>
                <c:pt idx="22">
                  <c:v>6.060982836</c:v>
                </c:pt>
                <c:pt idx="23">
                  <c:v>7.1275798229999996</c:v>
                </c:pt>
                <c:pt idx="24">
                  <c:v>6.9996444860000002</c:v>
                </c:pt>
                <c:pt idx="25">
                  <c:v>1.3207421239999999</c:v>
                </c:pt>
                <c:pt idx="26">
                  <c:v>5.3911759789999998</c:v>
                </c:pt>
                <c:pt idx="27">
                  <c:v>3.3331441979999998</c:v>
                </c:pt>
                <c:pt idx="28">
                  <c:v>3.5046871369999999</c:v>
                </c:pt>
                <c:pt idx="29">
                  <c:v>3.2649024780000002</c:v>
                </c:pt>
                <c:pt idx="30">
                  <c:v>3.771597479</c:v>
                </c:pt>
                <c:pt idx="31">
                  <c:v>2.9409640420000001</c:v>
                </c:pt>
                <c:pt idx="32">
                  <c:v>4.7284095920000002</c:v>
                </c:pt>
                <c:pt idx="33">
                  <c:v>9.4504517640000003</c:v>
                </c:pt>
                <c:pt idx="34">
                  <c:v>3.422435712</c:v>
                </c:pt>
                <c:pt idx="35">
                  <c:v>3.9183800799999999</c:v>
                </c:pt>
                <c:pt idx="36">
                  <c:v>8.2725597010000005</c:v>
                </c:pt>
                <c:pt idx="37">
                  <c:v>1.344515584</c:v>
                </c:pt>
                <c:pt idx="38">
                  <c:v>2.007855905</c:v>
                </c:pt>
                <c:pt idx="39">
                  <c:v>2.7393570770000002</c:v>
                </c:pt>
                <c:pt idx="40">
                  <c:v>6.9653623610000004</c:v>
                </c:pt>
                <c:pt idx="41">
                  <c:v>4.8005998590000001</c:v>
                </c:pt>
                <c:pt idx="42">
                  <c:v>7.0386809750000001</c:v>
                </c:pt>
                <c:pt idx="43">
                  <c:v>7.1907242340000002</c:v>
                </c:pt>
                <c:pt idx="44">
                  <c:v>5.0142994700000001</c:v>
                </c:pt>
                <c:pt idx="45">
                  <c:v>1.637225178</c:v>
                </c:pt>
                <c:pt idx="46">
                  <c:v>1.1192893690000001</c:v>
                </c:pt>
                <c:pt idx="47">
                  <c:v>2.193679317</c:v>
                </c:pt>
                <c:pt idx="48">
                  <c:v>1.7854284570000001</c:v>
                </c:pt>
                <c:pt idx="49">
                  <c:v>5.797896165</c:v>
                </c:pt>
                <c:pt idx="50">
                  <c:v>8.4933353139999994</c:v>
                </c:pt>
                <c:pt idx="51">
                  <c:v>7.9847093869999997</c:v>
                </c:pt>
                <c:pt idx="52">
                  <c:v>3.834658106</c:v>
                </c:pt>
                <c:pt idx="53">
                  <c:v>5.2005610610000002</c:v>
                </c:pt>
                <c:pt idx="54">
                  <c:v>10.75884697</c:v>
                </c:pt>
                <c:pt idx="55">
                  <c:v>7.5783694400000003</c:v>
                </c:pt>
                <c:pt idx="56">
                  <c:v>5.8549002149999998</c:v>
                </c:pt>
                <c:pt idx="57">
                  <c:v>5.0759789639999999</c:v>
                </c:pt>
                <c:pt idx="58">
                  <c:v>3.5754429669999999</c:v>
                </c:pt>
                <c:pt idx="59">
                  <c:v>7.7933786490000001</c:v>
                </c:pt>
                <c:pt idx="60">
                  <c:v>4.1727611180000004</c:v>
                </c:pt>
                <c:pt idx="61">
                  <c:v>6.2491337720000004</c:v>
                </c:pt>
                <c:pt idx="62">
                  <c:v>3.2050296409999999</c:v>
                </c:pt>
                <c:pt idx="63">
                  <c:v>7.7856595080000002</c:v>
                </c:pt>
                <c:pt idx="64">
                  <c:v>5.4374708829999996</c:v>
                </c:pt>
                <c:pt idx="65">
                  <c:v>3.1561638919999999</c:v>
                </c:pt>
                <c:pt idx="66">
                  <c:v>5.6336095909999999</c:v>
                </c:pt>
                <c:pt idx="67">
                  <c:v>4.2018126479999998</c:v>
                </c:pt>
                <c:pt idx="68">
                  <c:v>9.6656174139999997</c:v>
                </c:pt>
                <c:pt idx="69">
                  <c:v>4.325882086</c:v>
                </c:pt>
                <c:pt idx="70">
                  <c:v>0.51203456000000003</c:v>
                </c:pt>
                <c:pt idx="71">
                  <c:v>9.8031656989999991</c:v>
                </c:pt>
                <c:pt idx="72">
                  <c:v>3.7969780219999998</c:v>
                </c:pt>
                <c:pt idx="73">
                  <c:v>6.9996444860000002</c:v>
                </c:pt>
                <c:pt idx="74">
                  <c:v>6.0444262530000001</c:v>
                </c:pt>
                <c:pt idx="75">
                  <c:v>8.2257923890000004</c:v>
                </c:pt>
                <c:pt idx="76">
                  <c:v>7.0318262139999996</c:v>
                </c:pt>
                <c:pt idx="77">
                  <c:v>6.9996444860000002</c:v>
                </c:pt>
                <c:pt idx="78">
                  <c:v>10.436924769999999</c:v>
                </c:pt>
                <c:pt idx="79">
                  <c:v>7.7112409</c:v>
                </c:pt>
                <c:pt idx="80">
                  <c:v>2.9296597539999998</c:v>
                </c:pt>
                <c:pt idx="81">
                  <c:v>3.823960209</c:v>
                </c:pt>
                <c:pt idx="82">
                  <c:v>7.4497463310000001</c:v>
                </c:pt>
                <c:pt idx="83">
                  <c:v>9.2682531949999998</c:v>
                </c:pt>
                <c:pt idx="84">
                  <c:v>7.8066725119999996</c:v>
                </c:pt>
                <c:pt idx="85">
                  <c:v>9.3803932920000008</c:v>
                </c:pt>
                <c:pt idx="86">
                  <c:v>3.0497025290000002</c:v>
                </c:pt>
                <c:pt idx="87">
                  <c:v>10.959319280000001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-0.86913137900000004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1.9104255539999999</c:v>
                </c:pt>
                <c:pt idx="114">
                  <c:v>3.4196427539999998</c:v>
                </c:pt>
                <c:pt idx="115">
                  <c:v>3.1990087890000001</c:v>
                </c:pt>
                <c:pt idx="116">
                  <c:v>3.0444510980000001</c:v>
                </c:pt>
                <c:pt idx="117">
                  <c:v>3.1218248640000001</c:v>
                </c:pt>
                <c:pt idx="118">
                  <c:v>3.989568765</c:v>
                </c:pt>
                <c:pt idx="119">
                  <c:v>3.4023239699999999</c:v>
                </c:pt>
                <c:pt idx="120">
                  <c:v>3.4652172430000001</c:v>
                </c:pt>
                <c:pt idx="121">
                  <c:v>3.4717854739999998</c:v>
                </c:pt>
                <c:pt idx="122">
                  <c:v>3.7239160170000001</c:v>
                </c:pt>
                <c:pt idx="123">
                  <c:v>3.9793282200000002</c:v>
                </c:pt>
                <c:pt idx="124">
                  <c:v>3.6103820990000002</c:v>
                </c:pt>
                <c:pt idx="125">
                  <c:v>4.2079145059999998</c:v>
                </c:pt>
                <c:pt idx="126">
                  <c:v>2.732681683</c:v>
                </c:pt>
                <c:pt idx="127">
                  <c:v>2.3699310539999998</c:v>
                </c:pt>
                <c:pt idx="128">
                  <c:v>5.1189041729999998</c:v>
                </c:pt>
                <c:pt idx="129">
                  <c:v>4.7393300529999998</c:v>
                </c:pt>
                <c:pt idx="130">
                  <c:v>2.9348525520000002</c:v>
                </c:pt>
                <c:pt idx="131">
                  <c:v>3.4990621439999998</c:v>
                </c:pt>
                <c:pt idx="132">
                  <c:v>4.9891736829999997</c:v>
                </c:pt>
                <c:pt idx="133">
                  <c:v>4.8624698879999997</c:v>
                </c:pt>
                <c:pt idx="134">
                  <c:v>3.1173144009999998</c:v>
                </c:pt>
                <c:pt idx="135">
                  <c:v>4.0041280349999999</c:v>
                </c:pt>
                <c:pt idx="136">
                  <c:v>3.4972473530000001</c:v>
                </c:pt>
                <c:pt idx="137">
                  <c:v>4.30859141</c:v>
                </c:pt>
                <c:pt idx="138">
                  <c:v>4.9621315020000001</c:v>
                </c:pt>
                <c:pt idx="139">
                  <c:v>4.0130129840000004</c:v>
                </c:pt>
                <c:pt idx="140">
                  <c:v>0.64840397100000002</c:v>
                </c:pt>
                <c:pt idx="141">
                  <c:v>5.4282189110000001</c:v>
                </c:pt>
                <c:pt idx="142">
                  <c:v>2.9194108820000002</c:v>
                </c:pt>
                <c:pt idx="143">
                  <c:v>7.3789653609999997</c:v>
                </c:pt>
                <c:pt idx="144">
                  <c:v>2.5867741120000001</c:v>
                </c:pt>
                <c:pt idx="145">
                  <c:v>3.1301193719999998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6.1313241569999999</c:v>
                </c:pt>
                <c:pt idx="240">
                  <c:v>6.8884942010000003</c:v>
                </c:pt>
              </c:numCache>
            </c:numRef>
          </c:val>
        </c:ser>
        <c:ser>
          <c:idx val="2"/>
          <c:order val="2"/>
          <c:tx>
            <c:strRef>
              <c:f>Sheet1!$F$1</c:f>
              <c:strCache>
                <c:ptCount val="1"/>
                <c:pt idx="0">
                  <c:v>HPAT2</c:v>
                </c:pt>
              </c:strCache>
            </c:strRef>
          </c:tx>
          <c:spPr>
            <a:ln w="381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val>
            <c:numRef>
              <c:f>Sheet1!$F$2:$F$242</c:f>
              <c:numCache>
                <c:formatCode>General</c:formatCode>
                <c:ptCount val="24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-1.3723255510000001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-1.1610149030000001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2.6345949480000002</c:v>
                </c:pt>
                <c:pt idx="89">
                  <c:v>3.8854420589999998</c:v>
                </c:pt>
                <c:pt idx="90">
                  <c:v>2.7315017930000001</c:v>
                </c:pt>
                <c:pt idx="91">
                  <c:v>2.3242828819999999</c:v>
                </c:pt>
                <c:pt idx="92">
                  <c:v>2.9067377109999999</c:v>
                </c:pt>
                <c:pt idx="93">
                  <c:v>3.9820590359999999</c:v>
                </c:pt>
                <c:pt idx="94">
                  <c:v>3.8919508340000002</c:v>
                </c:pt>
                <c:pt idx="95">
                  <c:v>1.4720603720000001</c:v>
                </c:pt>
                <c:pt idx="96">
                  <c:v>4.5112534630000001</c:v>
                </c:pt>
                <c:pt idx="97">
                  <c:v>3.40292233</c:v>
                </c:pt>
                <c:pt idx="98">
                  <c:v>0.16710702899999999</c:v>
                </c:pt>
                <c:pt idx="99">
                  <c:v>6.285010357</c:v>
                </c:pt>
                <c:pt idx="100">
                  <c:v>5.1780957729999999</c:v>
                </c:pt>
                <c:pt idx="101">
                  <c:v>2.0436174380000001</c:v>
                </c:pt>
                <c:pt idx="102">
                  <c:v>0.59341937499999997</c:v>
                </c:pt>
                <c:pt idx="103">
                  <c:v>1.1165801120000001</c:v>
                </c:pt>
                <c:pt idx="104">
                  <c:v>4.284310208</c:v>
                </c:pt>
                <c:pt idx="105">
                  <c:v>3.7254184549999998</c:v>
                </c:pt>
                <c:pt idx="106">
                  <c:v>6.0012152060000004</c:v>
                </c:pt>
                <c:pt idx="107">
                  <c:v>4.2274467480000002</c:v>
                </c:pt>
                <c:pt idx="108">
                  <c:v>6.1486140059999999</c:v>
                </c:pt>
                <c:pt idx="109">
                  <c:v>2.7522529800000002</c:v>
                </c:pt>
                <c:pt idx="110">
                  <c:v>3.6425518499999998</c:v>
                </c:pt>
                <c:pt idx="111">
                  <c:v>2.9256091679999998</c:v>
                </c:pt>
                <c:pt idx="112">
                  <c:v>1.35850542</c:v>
                </c:pt>
                <c:pt idx="113">
                  <c:v>2.9579760070000001</c:v>
                </c:pt>
                <c:pt idx="114">
                  <c:v>3.3553319880000001</c:v>
                </c:pt>
                <c:pt idx="115">
                  <c:v>3.1683249409999998</c:v>
                </c:pt>
                <c:pt idx="116">
                  <c:v>3.3848362289999998</c:v>
                </c:pt>
                <c:pt idx="117">
                  <c:v>2.975747455</c:v>
                </c:pt>
                <c:pt idx="118">
                  <c:v>3.2924091230000001</c:v>
                </c:pt>
                <c:pt idx="119">
                  <c:v>2.576126822</c:v>
                </c:pt>
                <c:pt idx="120">
                  <c:v>3.3191049480000001</c:v>
                </c:pt>
                <c:pt idx="121">
                  <c:v>3.7752593409999999</c:v>
                </c:pt>
                <c:pt idx="122">
                  <c:v>3.743173927</c:v>
                </c:pt>
                <c:pt idx="123">
                  <c:v>3.7723614130000001</c:v>
                </c:pt>
                <c:pt idx="124">
                  <c:v>3.1713706820000001</c:v>
                </c:pt>
                <c:pt idx="125">
                  <c:v>3.3325664829999999</c:v>
                </c:pt>
                <c:pt idx="126">
                  <c:v>2.2870465790000001</c:v>
                </c:pt>
                <c:pt idx="127">
                  <c:v>2.9842021249999999</c:v>
                </c:pt>
                <c:pt idx="128">
                  <c:v>2.6969314440000001</c:v>
                </c:pt>
                <c:pt idx="129">
                  <c:v>4.102886678</c:v>
                </c:pt>
                <c:pt idx="130">
                  <c:v>6.890472033</c:v>
                </c:pt>
                <c:pt idx="131">
                  <c:v>3.7027362670000001</c:v>
                </c:pt>
                <c:pt idx="132">
                  <c:v>3.4532414239999998</c:v>
                </c:pt>
                <c:pt idx="133">
                  <c:v>3.3628207259999998</c:v>
                </c:pt>
                <c:pt idx="134">
                  <c:v>3.805301144</c:v>
                </c:pt>
                <c:pt idx="135">
                  <c:v>4.320395435</c:v>
                </c:pt>
                <c:pt idx="136">
                  <c:v>6.9937410770000001</c:v>
                </c:pt>
                <c:pt idx="137">
                  <c:v>4.5029680809999997</c:v>
                </c:pt>
                <c:pt idx="138">
                  <c:v>3.0504610699999999</c:v>
                </c:pt>
                <c:pt idx="139">
                  <c:v>4.320395435</c:v>
                </c:pt>
                <c:pt idx="140">
                  <c:v>7.2810172900000003</c:v>
                </c:pt>
                <c:pt idx="141">
                  <c:v>2.7446986619999998</c:v>
                </c:pt>
                <c:pt idx="142">
                  <c:v>3.890562912</c:v>
                </c:pt>
                <c:pt idx="143">
                  <c:v>5.729183087</c:v>
                </c:pt>
                <c:pt idx="144">
                  <c:v>3.022672268</c:v>
                </c:pt>
                <c:pt idx="145">
                  <c:v>3.1291214090000001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</c:numCache>
            </c:numRef>
          </c:val>
        </c:ser>
        <c:ser>
          <c:idx val="3"/>
          <c:order val="3"/>
          <c:tx>
            <c:strRef>
              <c:f>Sheet1!$G$1</c:f>
              <c:strCache>
                <c:ptCount val="1"/>
                <c:pt idx="0">
                  <c:v>HPAT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Sheet1!$G$2:$G$242</c:f>
              <c:numCache>
                <c:formatCode>General</c:formatCode>
                <c:ptCount val="24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6.5850011589999999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1.4652384220000001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3.7853105349999998</c:v>
                </c:pt>
                <c:pt idx="229">
                  <c:v>0.93394010100000002</c:v>
                </c:pt>
                <c:pt idx="230">
                  <c:v>2.7689936550000001</c:v>
                </c:pt>
                <c:pt idx="231">
                  <c:v>8.0325789150000002</c:v>
                </c:pt>
                <c:pt idx="232">
                  <c:v>5.253656222</c:v>
                </c:pt>
                <c:pt idx="233">
                  <c:v>4.6219283710000001</c:v>
                </c:pt>
                <c:pt idx="234">
                  <c:v>3.7711505789999999</c:v>
                </c:pt>
                <c:pt idx="235">
                  <c:v>4.0289328949999996</c:v>
                </c:pt>
                <c:pt idx="236">
                  <c:v>4.6950531739999999</c:v>
                </c:pt>
                <c:pt idx="237">
                  <c:v>3.2549860480000001</c:v>
                </c:pt>
                <c:pt idx="238">
                  <c:v>4.014578824</c:v>
                </c:pt>
                <c:pt idx="239">
                  <c:v>5.8848370259999996</c:v>
                </c:pt>
                <c:pt idx="240">
                  <c:v>6.292054912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5985280"/>
        <c:axId val="265981360"/>
      </c:radarChart>
      <c:catAx>
        <c:axId val="26598528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1360"/>
        <c:crosses val="autoZero"/>
        <c:auto val="1"/>
        <c:lblAlgn val="ctr"/>
        <c:lblOffset val="100"/>
        <c:noMultiLvlLbl val="0"/>
      </c:catAx>
      <c:valAx>
        <c:axId val="265981360"/>
        <c:scaling>
          <c:orientation val="minMax"/>
          <c:max val="1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5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dirty="0" smtClean="0">
                <a:solidFill>
                  <a:sysClr val="windowText" lastClr="000000"/>
                </a:solidFill>
              </a:rPr>
              <a:t>88 Early</a:t>
            </a:r>
            <a:r>
              <a:rPr lang="en-US" sz="1800" b="1" baseline="0" dirty="0" smtClean="0">
                <a:solidFill>
                  <a:sysClr val="windowText" lastClr="000000"/>
                </a:solidFill>
              </a:rPr>
              <a:t> </a:t>
            </a:r>
            <a:r>
              <a:rPr lang="en-US" sz="1800" b="1" baseline="0" dirty="0">
                <a:solidFill>
                  <a:sysClr val="windowText" lastClr="000000"/>
                </a:solidFill>
              </a:rPr>
              <a:t>Blastocyst Cells</a:t>
            </a:r>
            <a:endParaRPr lang="en-US" sz="1800" b="1" dirty="0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radarChart>
        <c:radarStyle val="marker"/>
        <c:varyColors val="0"/>
        <c:ser>
          <c:idx val="0"/>
          <c:order val="0"/>
          <c:tx>
            <c:strRef>
              <c:f>Early!$D$1</c:f>
              <c:strCache>
                <c:ptCount val="1"/>
                <c:pt idx="0">
                  <c:v>HPAT2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Early!$D$2:$D$89</c:f>
              <c:numCache>
                <c:formatCode>General</c:formatCode>
                <c:ptCount val="88"/>
                <c:pt idx="0">
                  <c:v>11.99873328</c:v>
                </c:pt>
                <c:pt idx="1">
                  <c:v>12.09656665</c:v>
                </c:pt>
                <c:pt idx="2">
                  <c:v>10.13427742</c:v>
                </c:pt>
                <c:pt idx="3">
                  <c:v>5.7545995220000004</c:v>
                </c:pt>
                <c:pt idx="4">
                  <c:v>5.2873062040000001</c:v>
                </c:pt>
                <c:pt idx="5">
                  <c:v>9.5741062479999997</c:v>
                </c:pt>
                <c:pt idx="6">
                  <c:v>11.191305699999999</c:v>
                </c:pt>
                <c:pt idx="7">
                  <c:v>9.4413358800000005</c:v>
                </c:pt>
                <c:pt idx="8">
                  <c:v>10.97115032</c:v>
                </c:pt>
                <c:pt idx="9">
                  <c:v>7.7423445859999998</c:v>
                </c:pt>
                <c:pt idx="10">
                  <c:v>11.50356021</c:v>
                </c:pt>
                <c:pt idx="11">
                  <c:v>11.41893282</c:v>
                </c:pt>
                <c:pt idx="12">
                  <c:v>8.3299059379999996</c:v>
                </c:pt>
                <c:pt idx="13">
                  <c:v>11.14788624</c:v>
                </c:pt>
                <c:pt idx="14">
                  <c:v>11.04963373</c:v>
                </c:pt>
                <c:pt idx="15">
                  <c:v>10.278764730000001</c:v>
                </c:pt>
                <c:pt idx="16">
                  <c:v>5.315456706</c:v>
                </c:pt>
                <c:pt idx="17">
                  <c:v>11.5565427</c:v>
                </c:pt>
                <c:pt idx="18">
                  <c:v>9.6389264959999998</c:v>
                </c:pt>
                <c:pt idx="19">
                  <c:v>9.0586594320000007</c:v>
                </c:pt>
                <c:pt idx="20">
                  <c:v>9.2414128519999998</c:v>
                </c:pt>
                <c:pt idx="21">
                  <c:v>7.1095627280000002</c:v>
                </c:pt>
                <c:pt idx="22">
                  <c:v>12.48149197</c:v>
                </c:pt>
                <c:pt idx="23">
                  <c:v>11.61118426</c:v>
                </c:pt>
                <c:pt idx="24">
                  <c:v>10.645449599999999</c:v>
                </c:pt>
                <c:pt idx="25">
                  <c:v>11.509520220000001</c:v>
                </c:pt>
                <c:pt idx="26">
                  <c:v>11.49715307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9.0330645040000004</c:v>
                </c:pt>
                <c:pt idx="34">
                  <c:v>9.2452232379999995</c:v>
                </c:pt>
                <c:pt idx="35">
                  <c:v>9.2604894580000003</c:v>
                </c:pt>
                <c:pt idx="36">
                  <c:v>9.9070771519999994</c:v>
                </c:pt>
                <c:pt idx="37">
                  <c:v>7.6784977359999997</c:v>
                </c:pt>
                <c:pt idx="38">
                  <c:v>8.7513392959999994</c:v>
                </c:pt>
                <c:pt idx="39">
                  <c:v>8.2399293710000006</c:v>
                </c:pt>
                <c:pt idx="40">
                  <c:v>7.8421158889999996</c:v>
                </c:pt>
                <c:pt idx="41">
                  <c:v>9.320875354</c:v>
                </c:pt>
                <c:pt idx="42">
                  <c:v>9.5174813070000006</c:v>
                </c:pt>
                <c:pt idx="43">
                  <c:v>9.9499931939999993</c:v>
                </c:pt>
                <c:pt idx="44">
                  <c:v>9.7179215879999994</c:v>
                </c:pt>
                <c:pt idx="45">
                  <c:v>9.3960813759999997</c:v>
                </c:pt>
                <c:pt idx="46">
                  <c:v>9.9017408870000008</c:v>
                </c:pt>
                <c:pt idx="47">
                  <c:v>8.9861219460000008</c:v>
                </c:pt>
                <c:pt idx="48">
                  <c:v>9.4770085739999992</c:v>
                </c:pt>
                <c:pt idx="49">
                  <c:v>8.7636199809999997</c:v>
                </c:pt>
                <c:pt idx="50">
                  <c:v>10.03357658</c:v>
                </c:pt>
                <c:pt idx="51">
                  <c:v>8.0073399260000002</c:v>
                </c:pt>
                <c:pt idx="52">
                  <c:v>9.3717993340000003</c:v>
                </c:pt>
                <c:pt idx="53">
                  <c:v>9.1778097340000002</c:v>
                </c:pt>
                <c:pt idx="54">
                  <c:v>8.7879346379999994</c:v>
                </c:pt>
                <c:pt idx="55">
                  <c:v>10.254375550000001</c:v>
                </c:pt>
                <c:pt idx="56">
                  <c:v>3.0057328980000002</c:v>
                </c:pt>
                <c:pt idx="57">
                  <c:v>13.422421290000001</c:v>
                </c:pt>
                <c:pt idx="58">
                  <c:v>8.7994767770000006</c:v>
                </c:pt>
                <c:pt idx="59">
                  <c:v>13.874650340000001</c:v>
                </c:pt>
                <c:pt idx="60">
                  <c:v>8.6742953909999994</c:v>
                </c:pt>
                <c:pt idx="61">
                  <c:v>8.7303543579999996</c:v>
                </c:pt>
                <c:pt idx="62">
                  <c:v>9.0835642389999993</c:v>
                </c:pt>
                <c:pt idx="63">
                  <c:v>12.383625990000001</c:v>
                </c:pt>
                <c:pt idx="64">
                  <c:v>8.5247452490000004</c:v>
                </c:pt>
                <c:pt idx="65">
                  <c:v>5.8660914980000003</c:v>
                </c:pt>
                <c:pt idx="66">
                  <c:v>11.50230284</c:v>
                </c:pt>
                <c:pt idx="67">
                  <c:v>10.405437040000001</c:v>
                </c:pt>
                <c:pt idx="68">
                  <c:v>10.121867590000001</c:v>
                </c:pt>
                <c:pt idx="69">
                  <c:v>8.7648517049999999</c:v>
                </c:pt>
                <c:pt idx="70">
                  <c:v>9.7256319449999999</c:v>
                </c:pt>
                <c:pt idx="71">
                  <c:v>8.5222880659999998</c:v>
                </c:pt>
                <c:pt idx="72">
                  <c:v>14.14588307</c:v>
                </c:pt>
                <c:pt idx="73">
                  <c:v>8.9349455259999999</c:v>
                </c:pt>
                <c:pt idx="74">
                  <c:v>11.89505561</c:v>
                </c:pt>
                <c:pt idx="75">
                  <c:v>7.5699177259999999</c:v>
                </c:pt>
                <c:pt idx="76">
                  <c:v>15.1767082</c:v>
                </c:pt>
                <c:pt idx="77">
                  <c:v>13.382433669999999</c:v>
                </c:pt>
                <c:pt idx="78">
                  <c:v>9.2357632029999994</c:v>
                </c:pt>
                <c:pt idx="79">
                  <c:v>14.314837259999999</c:v>
                </c:pt>
                <c:pt idx="80">
                  <c:v>8.9836593419999993</c:v>
                </c:pt>
                <c:pt idx="81">
                  <c:v>13.73097211</c:v>
                </c:pt>
                <c:pt idx="82">
                  <c:v>8.6599420560000002</c:v>
                </c:pt>
                <c:pt idx="83">
                  <c:v>0</c:v>
                </c:pt>
                <c:pt idx="84">
                  <c:v>9.8327566110000006</c:v>
                </c:pt>
                <c:pt idx="85">
                  <c:v>9.9776251029999994</c:v>
                </c:pt>
                <c:pt idx="86">
                  <c:v>9.3359428690000001</c:v>
                </c:pt>
                <c:pt idx="87">
                  <c:v>12.987317770000001</c:v>
                </c:pt>
              </c:numCache>
            </c:numRef>
          </c:val>
        </c:ser>
        <c:ser>
          <c:idx val="1"/>
          <c:order val="1"/>
          <c:tx>
            <c:strRef>
              <c:f>Early!$E$1</c:f>
              <c:strCache>
                <c:ptCount val="1"/>
                <c:pt idx="0">
                  <c:v>HPAT15</c:v>
                </c:pt>
              </c:strCache>
            </c:strRef>
          </c:tx>
          <c:spPr>
            <a:ln w="317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Early!$E$2:$E$89</c:f>
              <c:numCache>
                <c:formatCode>General</c:formatCode>
                <c:ptCount val="88"/>
                <c:pt idx="0">
                  <c:v>6.9996444860000002</c:v>
                </c:pt>
                <c:pt idx="1">
                  <c:v>9.8138476430000008</c:v>
                </c:pt>
                <c:pt idx="2">
                  <c:v>2.3446043009999999</c:v>
                </c:pt>
                <c:pt idx="3">
                  <c:v>3.3524538100000001</c:v>
                </c:pt>
                <c:pt idx="4">
                  <c:v>4.0931578569999996</c:v>
                </c:pt>
                <c:pt idx="5">
                  <c:v>4.4251827239999999</c:v>
                </c:pt>
                <c:pt idx="6">
                  <c:v>8.6669600990000006</c:v>
                </c:pt>
                <c:pt idx="7">
                  <c:v>5.1696126250000001</c:v>
                </c:pt>
                <c:pt idx="8">
                  <c:v>4.320395435</c:v>
                </c:pt>
                <c:pt idx="9">
                  <c:v>3.5046871369999999</c:v>
                </c:pt>
                <c:pt idx="10">
                  <c:v>8.2352069970000006</c:v>
                </c:pt>
                <c:pt idx="11">
                  <c:v>6.9996444860000002</c:v>
                </c:pt>
                <c:pt idx="12">
                  <c:v>6.2256769739999998</c:v>
                </c:pt>
                <c:pt idx="13">
                  <c:v>3.6770208360000001</c:v>
                </c:pt>
                <c:pt idx="14">
                  <c:v>8.7807667550000001</c:v>
                </c:pt>
                <c:pt idx="15">
                  <c:v>7.7136675930000003</c:v>
                </c:pt>
                <c:pt idx="16">
                  <c:v>2.8077451180000002</c:v>
                </c:pt>
                <c:pt idx="17">
                  <c:v>6.9996444860000002</c:v>
                </c:pt>
                <c:pt idx="18">
                  <c:v>4.8747249200000002</c:v>
                </c:pt>
                <c:pt idx="19">
                  <c:v>6.6067635090000003</c:v>
                </c:pt>
                <c:pt idx="20">
                  <c:v>6.0686000870000001</c:v>
                </c:pt>
                <c:pt idx="21">
                  <c:v>3.3608375960000001</c:v>
                </c:pt>
                <c:pt idx="22">
                  <c:v>6.060982836</c:v>
                </c:pt>
                <c:pt idx="23">
                  <c:v>7.1275798229999996</c:v>
                </c:pt>
                <c:pt idx="24">
                  <c:v>6.9996444860000002</c:v>
                </c:pt>
                <c:pt idx="25">
                  <c:v>6.1313241569999999</c:v>
                </c:pt>
                <c:pt idx="26">
                  <c:v>6.8884942010000003</c:v>
                </c:pt>
                <c:pt idx="27">
                  <c:v>1.3207421239999999</c:v>
                </c:pt>
                <c:pt idx="28">
                  <c:v>5.3911759789999998</c:v>
                </c:pt>
                <c:pt idx="29">
                  <c:v>3.3331441979999998</c:v>
                </c:pt>
                <c:pt idx="30">
                  <c:v>3.5046871369999999</c:v>
                </c:pt>
                <c:pt idx="31">
                  <c:v>3.2649024780000002</c:v>
                </c:pt>
                <c:pt idx="32">
                  <c:v>3.771597479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1.9104255539999999</c:v>
                </c:pt>
                <c:pt idx="38">
                  <c:v>3.4196427539999998</c:v>
                </c:pt>
                <c:pt idx="39">
                  <c:v>3.1990087890000001</c:v>
                </c:pt>
                <c:pt idx="40">
                  <c:v>3.0444510980000001</c:v>
                </c:pt>
                <c:pt idx="41">
                  <c:v>3.1218248640000001</c:v>
                </c:pt>
                <c:pt idx="42">
                  <c:v>3.989568765</c:v>
                </c:pt>
                <c:pt idx="43">
                  <c:v>3.4023239699999999</c:v>
                </c:pt>
                <c:pt idx="44">
                  <c:v>3.4652172430000001</c:v>
                </c:pt>
                <c:pt idx="45">
                  <c:v>3.4717854739999998</c:v>
                </c:pt>
                <c:pt idx="46">
                  <c:v>3.7239160170000001</c:v>
                </c:pt>
                <c:pt idx="47">
                  <c:v>3.9793282200000002</c:v>
                </c:pt>
                <c:pt idx="48">
                  <c:v>3.6103820990000002</c:v>
                </c:pt>
                <c:pt idx="49">
                  <c:v>4.2079145059999998</c:v>
                </c:pt>
                <c:pt idx="50">
                  <c:v>2.732681683</c:v>
                </c:pt>
                <c:pt idx="51">
                  <c:v>2.3699310539999998</c:v>
                </c:pt>
                <c:pt idx="52">
                  <c:v>5.1189041729999998</c:v>
                </c:pt>
                <c:pt idx="53">
                  <c:v>3.1301193719999998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</c:numCache>
            </c:numRef>
          </c:val>
        </c:ser>
        <c:ser>
          <c:idx val="2"/>
          <c:order val="2"/>
          <c:tx>
            <c:strRef>
              <c:f>Early!$F$1</c:f>
              <c:strCache>
                <c:ptCount val="1"/>
                <c:pt idx="0">
                  <c:v>HPAT2</c:v>
                </c:pt>
              </c:strCache>
            </c:strRef>
          </c:tx>
          <c:spPr>
            <a:ln w="381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val>
            <c:numRef>
              <c:f>Early!$F$2:$F$89</c:f>
              <c:numCache>
                <c:formatCode>General</c:formatCode>
                <c:ptCount val="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2.6345949480000002</c:v>
                </c:pt>
                <c:pt idx="34">
                  <c:v>3.8854420589999998</c:v>
                </c:pt>
                <c:pt idx="35">
                  <c:v>2.7315017930000001</c:v>
                </c:pt>
                <c:pt idx="36">
                  <c:v>2.3242828819999999</c:v>
                </c:pt>
                <c:pt idx="37">
                  <c:v>2.9579760070000001</c:v>
                </c:pt>
                <c:pt idx="38">
                  <c:v>3.3553319880000001</c:v>
                </c:pt>
                <c:pt idx="39">
                  <c:v>3.1683249409999998</c:v>
                </c:pt>
                <c:pt idx="40">
                  <c:v>3.3848362289999998</c:v>
                </c:pt>
                <c:pt idx="41">
                  <c:v>2.975747455</c:v>
                </c:pt>
                <c:pt idx="42">
                  <c:v>3.2924091230000001</c:v>
                </c:pt>
                <c:pt idx="43">
                  <c:v>2.576126822</c:v>
                </c:pt>
                <c:pt idx="44">
                  <c:v>3.3191049480000001</c:v>
                </c:pt>
                <c:pt idx="45">
                  <c:v>3.7752593409999999</c:v>
                </c:pt>
                <c:pt idx="46">
                  <c:v>3.743173927</c:v>
                </c:pt>
                <c:pt idx="47">
                  <c:v>3.7723614130000001</c:v>
                </c:pt>
                <c:pt idx="48">
                  <c:v>3.1713706820000001</c:v>
                </c:pt>
                <c:pt idx="49">
                  <c:v>3.3325664829999999</c:v>
                </c:pt>
                <c:pt idx="50">
                  <c:v>2.2870465790000001</c:v>
                </c:pt>
                <c:pt idx="51">
                  <c:v>2.9842021249999999</c:v>
                </c:pt>
                <c:pt idx="52">
                  <c:v>2.6969314440000001</c:v>
                </c:pt>
                <c:pt idx="53">
                  <c:v>3.1291214090000001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</c:numCache>
            </c:numRef>
          </c:val>
        </c:ser>
        <c:ser>
          <c:idx val="3"/>
          <c:order val="3"/>
          <c:tx>
            <c:strRef>
              <c:f>Early!$G$1</c:f>
              <c:strCache>
                <c:ptCount val="1"/>
                <c:pt idx="0">
                  <c:v>HPAT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Early!$G$2:$G$89</c:f>
              <c:numCache>
                <c:formatCode>General</c:formatCode>
                <c:ptCount val="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5.8848370259999996</c:v>
                </c:pt>
                <c:pt idx="26">
                  <c:v>6.292054912000000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.4652384220000001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3.7853105349999998</c:v>
                </c:pt>
                <c:pt idx="85">
                  <c:v>0.93394010100000002</c:v>
                </c:pt>
                <c:pt idx="86">
                  <c:v>2.7689936550000001</c:v>
                </c:pt>
                <c:pt idx="87">
                  <c:v>8.032578915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5982144"/>
        <c:axId val="265983712"/>
      </c:radarChart>
      <c:catAx>
        <c:axId val="26598214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3712"/>
        <c:crosses val="autoZero"/>
        <c:auto val="1"/>
        <c:lblAlgn val="ctr"/>
        <c:lblOffset val="100"/>
        <c:noMultiLvlLbl val="0"/>
      </c:catAx>
      <c:valAx>
        <c:axId val="2659837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9821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dirty="0" smtClean="0">
                <a:solidFill>
                  <a:sysClr val="windowText" lastClr="000000"/>
                </a:solidFill>
              </a:rPr>
              <a:t>153 Late</a:t>
            </a:r>
            <a:r>
              <a:rPr lang="en-US" sz="1800" b="1" baseline="0" dirty="0" smtClean="0">
                <a:solidFill>
                  <a:sysClr val="windowText" lastClr="000000"/>
                </a:solidFill>
              </a:rPr>
              <a:t> </a:t>
            </a:r>
            <a:r>
              <a:rPr lang="en-US" sz="1800" b="1" baseline="0" dirty="0">
                <a:solidFill>
                  <a:sysClr val="windowText" lastClr="000000"/>
                </a:solidFill>
              </a:rPr>
              <a:t>Blastocyst Cells</a:t>
            </a:r>
            <a:endParaRPr lang="en-US" sz="1800" b="1" dirty="0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radarChart>
        <c:radarStyle val="marker"/>
        <c:varyColors val="0"/>
        <c:ser>
          <c:idx val="0"/>
          <c:order val="0"/>
          <c:tx>
            <c:strRef>
              <c:f>Late!$D$1</c:f>
              <c:strCache>
                <c:ptCount val="1"/>
                <c:pt idx="0">
                  <c:v>HPAT2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Late!$D$2:$D$154</c:f>
              <c:numCache>
                <c:formatCode>General</c:formatCode>
                <c:ptCount val="153"/>
                <c:pt idx="0">
                  <c:v>9.558829867</c:v>
                </c:pt>
                <c:pt idx="1">
                  <c:v>11.419728510000001</c:v>
                </c:pt>
                <c:pt idx="2">
                  <c:v>12.59500261</c:v>
                </c:pt>
                <c:pt idx="3">
                  <c:v>8.8265643209999993</c:v>
                </c:pt>
                <c:pt idx="4">
                  <c:v>9.2752559699999999</c:v>
                </c:pt>
                <c:pt idx="5">
                  <c:v>11.86805801</c:v>
                </c:pt>
                <c:pt idx="6">
                  <c:v>6.9712677320000003</c:v>
                </c:pt>
                <c:pt idx="7">
                  <c:v>9.092474245</c:v>
                </c:pt>
                <c:pt idx="8">
                  <c:v>8.9943366400000002</c:v>
                </c:pt>
                <c:pt idx="9">
                  <c:v>12.529868909999999</c:v>
                </c:pt>
                <c:pt idx="10">
                  <c:v>14.033336050000001</c:v>
                </c:pt>
                <c:pt idx="11">
                  <c:v>13.276352060000001</c:v>
                </c:pt>
                <c:pt idx="12">
                  <c:v>11.63699366</c:v>
                </c:pt>
                <c:pt idx="13">
                  <c:v>10.075975120000001</c:v>
                </c:pt>
                <c:pt idx="14">
                  <c:v>7.7950492029999996</c:v>
                </c:pt>
                <c:pt idx="15">
                  <c:v>8.8695645110000001</c:v>
                </c:pt>
                <c:pt idx="16">
                  <c:v>10.090433190000001</c:v>
                </c:pt>
                <c:pt idx="17">
                  <c:v>9.7654756549999995</c:v>
                </c:pt>
                <c:pt idx="18">
                  <c:v>11.228448350000001</c:v>
                </c:pt>
                <c:pt idx="19">
                  <c:v>12.10672969</c:v>
                </c:pt>
                <c:pt idx="20">
                  <c:v>12.946798920000001</c:v>
                </c:pt>
                <c:pt idx="21">
                  <c:v>9.8251244930000006</c:v>
                </c:pt>
                <c:pt idx="22">
                  <c:v>8.9613813580000006</c:v>
                </c:pt>
                <c:pt idx="23">
                  <c:v>13.85670767</c:v>
                </c:pt>
                <c:pt idx="24">
                  <c:v>12.60755625</c:v>
                </c:pt>
                <c:pt idx="25">
                  <c:v>9.2933112040000001</c:v>
                </c:pt>
                <c:pt idx="26">
                  <c:v>9.6009175689999999</c:v>
                </c:pt>
                <c:pt idx="27">
                  <c:v>12.579351559999999</c:v>
                </c:pt>
                <c:pt idx="28">
                  <c:v>13.5442982</c:v>
                </c:pt>
                <c:pt idx="29">
                  <c:v>11.628524669999999</c:v>
                </c:pt>
                <c:pt idx="30">
                  <c:v>10.9684515</c:v>
                </c:pt>
                <c:pt idx="31">
                  <c:v>9.906762252</c:v>
                </c:pt>
                <c:pt idx="32">
                  <c:v>13.149525580000001</c:v>
                </c:pt>
                <c:pt idx="33">
                  <c:v>10.30622556</c:v>
                </c:pt>
                <c:pt idx="34">
                  <c:v>8.7947638690000005</c:v>
                </c:pt>
                <c:pt idx="35">
                  <c:v>12.062914320000001</c:v>
                </c:pt>
                <c:pt idx="36">
                  <c:v>10.463341079999999</c:v>
                </c:pt>
                <c:pt idx="37">
                  <c:v>14.298528279999999</c:v>
                </c:pt>
                <c:pt idx="38">
                  <c:v>9.5730352609999994</c:v>
                </c:pt>
                <c:pt idx="39">
                  <c:v>12.783326990000001</c:v>
                </c:pt>
                <c:pt idx="40">
                  <c:v>12.246702170000001</c:v>
                </c:pt>
                <c:pt idx="41">
                  <c:v>9.8184804470000007</c:v>
                </c:pt>
                <c:pt idx="42">
                  <c:v>11.740371740000001</c:v>
                </c:pt>
                <c:pt idx="43">
                  <c:v>10.047336899999999</c:v>
                </c:pt>
                <c:pt idx="44">
                  <c:v>10.64002268</c:v>
                </c:pt>
                <c:pt idx="45">
                  <c:v>12.279840780000001</c:v>
                </c:pt>
                <c:pt idx="46">
                  <c:v>12.04419204</c:v>
                </c:pt>
                <c:pt idx="47">
                  <c:v>13.29778217</c:v>
                </c:pt>
                <c:pt idx="48">
                  <c:v>10.20815657</c:v>
                </c:pt>
                <c:pt idx="49">
                  <c:v>8.8188217630000008</c:v>
                </c:pt>
                <c:pt idx="50">
                  <c:v>13.81619759</c:v>
                </c:pt>
                <c:pt idx="51">
                  <c:v>11.579533830000001</c:v>
                </c:pt>
                <c:pt idx="52">
                  <c:v>12.546473130000001</c:v>
                </c:pt>
                <c:pt idx="53">
                  <c:v>13.59995793</c:v>
                </c:pt>
                <c:pt idx="54">
                  <c:v>12.89354855</c:v>
                </c:pt>
                <c:pt idx="55">
                  <c:v>10.875782429999999</c:v>
                </c:pt>
                <c:pt idx="56">
                  <c:v>13.53578914</c:v>
                </c:pt>
                <c:pt idx="57">
                  <c:v>8.521000634</c:v>
                </c:pt>
                <c:pt idx="58">
                  <c:v>8.4581842149999993</c:v>
                </c:pt>
                <c:pt idx="59">
                  <c:v>9.4746934409999994</c:v>
                </c:pt>
                <c:pt idx="60">
                  <c:v>9.8537901229999996</c:v>
                </c:pt>
                <c:pt idx="61">
                  <c:v>9.0151419330000007</c:v>
                </c:pt>
                <c:pt idx="62">
                  <c:v>9.5186147420000005</c:v>
                </c:pt>
                <c:pt idx="63">
                  <c:v>6.7153747399999997</c:v>
                </c:pt>
                <c:pt idx="64">
                  <c:v>7.3983567470000002</c:v>
                </c:pt>
                <c:pt idx="65">
                  <c:v>6.8419123949999996</c:v>
                </c:pt>
                <c:pt idx="66">
                  <c:v>9.1059359400000002</c:v>
                </c:pt>
                <c:pt idx="67">
                  <c:v>11.41001146</c:v>
                </c:pt>
                <c:pt idx="68">
                  <c:v>11.96716417</c:v>
                </c:pt>
                <c:pt idx="69">
                  <c:v>9.6308498020000002</c:v>
                </c:pt>
                <c:pt idx="70">
                  <c:v>10.02052555</c:v>
                </c:pt>
                <c:pt idx="71">
                  <c:v>7.7943884399999996</c:v>
                </c:pt>
                <c:pt idx="72">
                  <c:v>9.2745528559999997</c:v>
                </c:pt>
                <c:pt idx="73">
                  <c:v>7.6357183449999999</c:v>
                </c:pt>
                <c:pt idx="74">
                  <c:v>4.6151159770000003</c:v>
                </c:pt>
                <c:pt idx="75">
                  <c:v>11.245972699999999</c:v>
                </c:pt>
                <c:pt idx="76">
                  <c:v>3.6535841269999998</c:v>
                </c:pt>
                <c:pt idx="77">
                  <c:v>11.492176430000001</c:v>
                </c:pt>
                <c:pt idx="78">
                  <c:v>10.24437818</c:v>
                </c:pt>
                <c:pt idx="79">
                  <c:v>7.324374079</c:v>
                </c:pt>
                <c:pt idx="80">
                  <c:v>9.0150677829999992</c:v>
                </c:pt>
                <c:pt idx="81">
                  <c:v>9.5703522779999997</c:v>
                </c:pt>
                <c:pt idx="82">
                  <c:v>9.6221092049999992</c:v>
                </c:pt>
                <c:pt idx="83">
                  <c:v>9.2542914399999994</c:v>
                </c:pt>
                <c:pt idx="84">
                  <c:v>10.18147076</c:v>
                </c:pt>
                <c:pt idx="85">
                  <c:v>11.470322899999999</c:v>
                </c:pt>
                <c:pt idx="86">
                  <c:v>10.304745670000001</c:v>
                </c:pt>
                <c:pt idx="87">
                  <c:v>9.1870411440000002</c:v>
                </c:pt>
                <c:pt idx="88">
                  <c:v>10.838005920000001</c:v>
                </c:pt>
                <c:pt idx="89">
                  <c:v>7.0548333789999997</c:v>
                </c:pt>
                <c:pt idx="90">
                  <c:v>12.92020327</c:v>
                </c:pt>
                <c:pt idx="91">
                  <c:v>9.9930027389999996</c:v>
                </c:pt>
                <c:pt idx="92">
                  <c:v>10.82369712</c:v>
                </c:pt>
                <c:pt idx="93">
                  <c:v>9.0384907709999993</c:v>
                </c:pt>
                <c:pt idx="94">
                  <c:v>15.15021438</c:v>
                </c:pt>
                <c:pt idx="95">
                  <c:v>11.2064789</c:v>
                </c:pt>
                <c:pt idx="96">
                  <c:v>12.4402782</c:v>
                </c:pt>
                <c:pt idx="97">
                  <c:v>10.823246210000001</c:v>
                </c:pt>
                <c:pt idx="98">
                  <c:v>13.83920966</c:v>
                </c:pt>
                <c:pt idx="99">
                  <c:v>13.49463211</c:v>
                </c:pt>
                <c:pt idx="100">
                  <c:v>16.087255899999999</c:v>
                </c:pt>
                <c:pt idx="101">
                  <c:v>8.5814796829999995</c:v>
                </c:pt>
                <c:pt idx="102">
                  <c:v>11.66762662</c:v>
                </c:pt>
                <c:pt idx="103">
                  <c:v>13.951573939999999</c:v>
                </c:pt>
                <c:pt idx="104">
                  <c:v>12.05683786</c:v>
                </c:pt>
                <c:pt idx="105">
                  <c:v>10.6800382</c:v>
                </c:pt>
                <c:pt idx="106">
                  <c:v>9.1448827070000007</c:v>
                </c:pt>
                <c:pt idx="107">
                  <c:v>9.2675851429999998</c:v>
                </c:pt>
                <c:pt idx="108">
                  <c:v>11.01545707</c:v>
                </c:pt>
                <c:pt idx="109">
                  <c:v>7.9953558180000002</c:v>
                </c:pt>
                <c:pt idx="110">
                  <c:v>8.8651370939999996</c:v>
                </c:pt>
                <c:pt idx="111">
                  <c:v>9.6499371390000004</c:v>
                </c:pt>
                <c:pt idx="112">
                  <c:v>8.224094333</c:v>
                </c:pt>
                <c:pt idx="113">
                  <c:v>9.4934328420000007</c:v>
                </c:pt>
                <c:pt idx="114">
                  <c:v>8.2568802899999998</c:v>
                </c:pt>
                <c:pt idx="115">
                  <c:v>13.49369866</c:v>
                </c:pt>
                <c:pt idx="116">
                  <c:v>9.6881992550000007</c:v>
                </c:pt>
                <c:pt idx="117">
                  <c:v>8.994670352</c:v>
                </c:pt>
                <c:pt idx="118">
                  <c:v>10.693199890000001</c:v>
                </c:pt>
                <c:pt idx="119">
                  <c:v>8.7137384359999999</c:v>
                </c:pt>
                <c:pt idx="120">
                  <c:v>11.452228180000001</c:v>
                </c:pt>
                <c:pt idx="121">
                  <c:v>11.5651113</c:v>
                </c:pt>
                <c:pt idx="122">
                  <c:v>9.1383961320000004</c:v>
                </c:pt>
                <c:pt idx="123">
                  <c:v>8.8386195910000005</c:v>
                </c:pt>
                <c:pt idx="124">
                  <c:v>9.3409282499999993</c:v>
                </c:pt>
                <c:pt idx="125">
                  <c:v>9.7540076550000006</c:v>
                </c:pt>
                <c:pt idx="126">
                  <c:v>12.059088170000001</c:v>
                </c:pt>
                <c:pt idx="127">
                  <c:v>9.2657596410000007</c:v>
                </c:pt>
                <c:pt idx="128">
                  <c:v>13.055139499999999</c:v>
                </c:pt>
                <c:pt idx="129">
                  <c:v>11.97987575</c:v>
                </c:pt>
                <c:pt idx="130">
                  <c:v>10.76630201</c:v>
                </c:pt>
                <c:pt idx="131">
                  <c:v>9.3522181389999997</c:v>
                </c:pt>
                <c:pt idx="132">
                  <c:v>11.331466949999999</c:v>
                </c:pt>
                <c:pt idx="133">
                  <c:v>8.9663466290000002</c:v>
                </c:pt>
                <c:pt idx="134">
                  <c:v>8.8485732939999995</c:v>
                </c:pt>
                <c:pt idx="135">
                  <c:v>9.2245337559999996</c:v>
                </c:pt>
                <c:pt idx="136">
                  <c:v>8.7657777419999992</c:v>
                </c:pt>
                <c:pt idx="137">
                  <c:v>9.3253948900000001</c:v>
                </c:pt>
                <c:pt idx="138">
                  <c:v>8.8393793630000008</c:v>
                </c:pt>
                <c:pt idx="139">
                  <c:v>11.31452889</c:v>
                </c:pt>
                <c:pt idx="140">
                  <c:v>9.4367379079999996</c:v>
                </c:pt>
                <c:pt idx="141">
                  <c:v>9.6909964290000001</c:v>
                </c:pt>
                <c:pt idx="142">
                  <c:v>10.079952349999999</c:v>
                </c:pt>
                <c:pt idx="143">
                  <c:v>11.17803099</c:v>
                </c:pt>
                <c:pt idx="144">
                  <c:v>11.443634749999999</c:v>
                </c:pt>
                <c:pt idx="145">
                  <c:v>9.5549889750000006</c:v>
                </c:pt>
                <c:pt idx="146">
                  <c:v>8.9306590610000001</c:v>
                </c:pt>
                <c:pt idx="147">
                  <c:v>8.3854919599999995</c:v>
                </c:pt>
                <c:pt idx="148">
                  <c:v>9.0432355609999995</c:v>
                </c:pt>
                <c:pt idx="149">
                  <c:v>8.6321694400000002</c:v>
                </c:pt>
                <c:pt idx="150">
                  <c:v>8.5734262290000007</c:v>
                </c:pt>
                <c:pt idx="151">
                  <c:v>10.929428059999999</c:v>
                </c:pt>
                <c:pt idx="152">
                  <c:v>11.44340375</c:v>
                </c:pt>
              </c:numCache>
            </c:numRef>
          </c:val>
        </c:ser>
        <c:ser>
          <c:idx val="1"/>
          <c:order val="1"/>
          <c:tx>
            <c:strRef>
              <c:f>Late!$E$1</c:f>
              <c:strCache>
                <c:ptCount val="1"/>
                <c:pt idx="0">
                  <c:v>HPAT15</c:v>
                </c:pt>
              </c:strCache>
            </c:strRef>
          </c:tx>
          <c:spPr>
            <a:ln w="317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Late!$E$2:$E$154</c:f>
              <c:numCache>
                <c:formatCode>General</c:formatCode>
                <c:ptCount val="153"/>
                <c:pt idx="0">
                  <c:v>2.9409640420000001</c:v>
                </c:pt>
                <c:pt idx="1">
                  <c:v>4.7284095920000002</c:v>
                </c:pt>
                <c:pt idx="2">
                  <c:v>9.4504517640000003</c:v>
                </c:pt>
                <c:pt idx="3">
                  <c:v>3.422435712</c:v>
                </c:pt>
                <c:pt idx="4">
                  <c:v>3.9183800799999999</c:v>
                </c:pt>
                <c:pt idx="5">
                  <c:v>8.2725597010000005</c:v>
                </c:pt>
                <c:pt idx="6">
                  <c:v>1.344515584</c:v>
                </c:pt>
                <c:pt idx="7">
                  <c:v>2.007855905</c:v>
                </c:pt>
                <c:pt idx="8">
                  <c:v>2.7393570770000002</c:v>
                </c:pt>
                <c:pt idx="9">
                  <c:v>6.9653623610000004</c:v>
                </c:pt>
                <c:pt idx="10">
                  <c:v>4.8005998590000001</c:v>
                </c:pt>
                <c:pt idx="11">
                  <c:v>7.0386809750000001</c:v>
                </c:pt>
                <c:pt idx="12">
                  <c:v>7.1907242340000002</c:v>
                </c:pt>
                <c:pt idx="13">
                  <c:v>5.0142994700000001</c:v>
                </c:pt>
                <c:pt idx="14">
                  <c:v>1.637225178</c:v>
                </c:pt>
                <c:pt idx="15">
                  <c:v>1.1192893690000001</c:v>
                </c:pt>
                <c:pt idx="16">
                  <c:v>2.193679317</c:v>
                </c:pt>
                <c:pt idx="17">
                  <c:v>1.7854284570000001</c:v>
                </c:pt>
                <c:pt idx="18">
                  <c:v>5.797896165</c:v>
                </c:pt>
                <c:pt idx="19">
                  <c:v>8.4933353139999994</c:v>
                </c:pt>
                <c:pt idx="20">
                  <c:v>7.9847093869999997</c:v>
                </c:pt>
                <c:pt idx="21">
                  <c:v>3.834658106</c:v>
                </c:pt>
                <c:pt idx="22">
                  <c:v>5.2005610610000002</c:v>
                </c:pt>
                <c:pt idx="23">
                  <c:v>10.75884697</c:v>
                </c:pt>
                <c:pt idx="24">
                  <c:v>7.5783694400000003</c:v>
                </c:pt>
                <c:pt idx="25">
                  <c:v>5.8549002149999998</c:v>
                </c:pt>
                <c:pt idx="26">
                  <c:v>5.0759789639999999</c:v>
                </c:pt>
                <c:pt idx="27">
                  <c:v>3.5754429669999999</c:v>
                </c:pt>
                <c:pt idx="28">
                  <c:v>7.7933786490000001</c:v>
                </c:pt>
                <c:pt idx="29">
                  <c:v>4.1727611180000004</c:v>
                </c:pt>
                <c:pt idx="30">
                  <c:v>6.2491337720000004</c:v>
                </c:pt>
                <c:pt idx="31">
                  <c:v>3.2050296409999999</c:v>
                </c:pt>
                <c:pt idx="32">
                  <c:v>7.7856595080000002</c:v>
                </c:pt>
                <c:pt idx="33">
                  <c:v>5.4374708829999996</c:v>
                </c:pt>
                <c:pt idx="34">
                  <c:v>3.1561638919999999</c:v>
                </c:pt>
                <c:pt idx="35">
                  <c:v>5.6336095909999999</c:v>
                </c:pt>
                <c:pt idx="36">
                  <c:v>4.2018126479999998</c:v>
                </c:pt>
                <c:pt idx="37">
                  <c:v>9.6656174139999997</c:v>
                </c:pt>
                <c:pt idx="38">
                  <c:v>4.325882086</c:v>
                </c:pt>
                <c:pt idx="39">
                  <c:v>0.51203456000000003</c:v>
                </c:pt>
                <c:pt idx="40">
                  <c:v>9.8031656989999991</c:v>
                </c:pt>
                <c:pt idx="41">
                  <c:v>3.7969780219999998</c:v>
                </c:pt>
                <c:pt idx="42">
                  <c:v>6.9996444860000002</c:v>
                </c:pt>
                <c:pt idx="43">
                  <c:v>6.0444262530000001</c:v>
                </c:pt>
                <c:pt idx="44">
                  <c:v>8.2257923890000004</c:v>
                </c:pt>
                <c:pt idx="45">
                  <c:v>7.0318262139999996</c:v>
                </c:pt>
                <c:pt idx="46">
                  <c:v>6.9996444860000002</c:v>
                </c:pt>
                <c:pt idx="47">
                  <c:v>10.436924769999999</c:v>
                </c:pt>
                <c:pt idx="48">
                  <c:v>7.7112409</c:v>
                </c:pt>
                <c:pt idx="49">
                  <c:v>2.9296597539999998</c:v>
                </c:pt>
                <c:pt idx="50">
                  <c:v>3.823960209</c:v>
                </c:pt>
                <c:pt idx="51">
                  <c:v>7.4497463310000001</c:v>
                </c:pt>
                <c:pt idx="52">
                  <c:v>9.2682531949999998</c:v>
                </c:pt>
                <c:pt idx="53">
                  <c:v>7.8066725119999996</c:v>
                </c:pt>
                <c:pt idx="54">
                  <c:v>9.3803932920000008</c:v>
                </c:pt>
                <c:pt idx="55">
                  <c:v>3.0497025290000002</c:v>
                </c:pt>
                <c:pt idx="56">
                  <c:v>10.959319280000001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-0.86913137900000004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4.7393300529999998</c:v>
                </c:pt>
                <c:pt idx="79">
                  <c:v>2.9348525520000002</c:v>
                </c:pt>
                <c:pt idx="80">
                  <c:v>3.4990621439999998</c:v>
                </c:pt>
                <c:pt idx="81">
                  <c:v>4.9891736829999997</c:v>
                </c:pt>
                <c:pt idx="82">
                  <c:v>4.8624698879999997</c:v>
                </c:pt>
                <c:pt idx="83">
                  <c:v>3.1173144009999998</c:v>
                </c:pt>
                <c:pt idx="84">
                  <c:v>4.0041280349999999</c:v>
                </c:pt>
                <c:pt idx="85">
                  <c:v>3.4972473530000001</c:v>
                </c:pt>
                <c:pt idx="86">
                  <c:v>4.30859141</c:v>
                </c:pt>
                <c:pt idx="87">
                  <c:v>4.9621315020000001</c:v>
                </c:pt>
                <c:pt idx="88">
                  <c:v>4.0130129840000004</c:v>
                </c:pt>
                <c:pt idx="89">
                  <c:v>0.64840397100000002</c:v>
                </c:pt>
                <c:pt idx="90">
                  <c:v>5.4282189110000001</c:v>
                </c:pt>
                <c:pt idx="91">
                  <c:v>2.9194108820000002</c:v>
                </c:pt>
                <c:pt idx="92">
                  <c:v>7.3789653609999997</c:v>
                </c:pt>
                <c:pt idx="93">
                  <c:v>2.5867741120000001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</c:numCache>
            </c:numRef>
          </c:val>
        </c:ser>
        <c:ser>
          <c:idx val="2"/>
          <c:order val="2"/>
          <c:tx>
            <c:strRef>
              <c:f>Late!$F$1</c:f>
              <c:strCache>
                <c:ptCount val="1"/>
                <c:pt idx="0">
                  <c:v>HPAT2</c:v>
                </c:pt>
              </c:strCache>
            </c:strRef>
          </c:tx>
          <c:spPr>
            <a:ln w="381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val>
            <c:numRef>
              <c:f>Late!$F$2:$F$154</c:f>
              <c:numCache>
                <c:formatCode>General</c:formatCode>
                <c:ptCount val="15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-1.372325551000000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-1.1610149030000001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2.9067377109999999</c:v>
                </c:pt>
                <c:pt idx="58">
                  <c:v>3.9820590359999999</c:v>
                </c:pt>
                <c:pt idx="59">
                  <c:v>3.8919508340000002</c:v>
                </c:pt>
                <c:pt idx="60">
                  <c:v>1.4720603720000001</c:v>
                </c:pt>
                <c:pt idx="61">
                  <c:v>4.5112534630000001</c:v>
                </c:pt>
                <c:pt idx="62">
                  <c:v>3.40292233</c:v>
                </c:pt>
                <c:pt idx="63">
                  <c:v>0.16710702899999999</c:v>
                </c:pt>
                <c:pt idx="64">
                  <c:v>6.285010357</c:v>
                </c:pt>
                <c:pt idx="65">
                  <c:v>5.1780957729999999</c:v>
                </c:pt>
                <c:pt idx="66">
                  <c:v>2.0436174380000001</c:v>
                </c:pt>
                <c:pt idx="67">
                  <c:v>0.59341937499999997</c:v>
                </c:pt>
                <c:pt idx="68">
                  <c:v>1.1165801120000001</c:v>
                </c:pt>
                <c:pt idx="69">
                  <c:v>4.284310208</c:v>
                </c:pt>
                <c:pt idx="70">
                  <c:v>3.7254184549999998</c:v>
                </c:pt>
                <c:pt idx="71">
                  <c:v>6.0012152060000004</c:v>
                </c:pt>
                <c:pt idx="72">
                  <c:v>4.2274467480000002</c:v>
                </c:pt>
                <c:pt idx="73">
                  <c:v>6.1486140059999999</c:v>
                </c:pt>
                <c:pt idx="74">
                  <c:v>2.7522529800000002</c:v>
                </c:pt>
                <c:pt idx="75">
                  <c:v>3.6425518499999998</c:v>
                </c:pt>
                <c:pt idx="76">
                  <c:v>2.9256091679999998</c:v>
                </c:pt>
                <c:pt idx="77">
                  <c:v>1.35850542</c:v>
                </c:pt>
                <c:pt idx="78">
                  <c:v>4.102886678</c:v>
                </c:pt>
                <c:pt idx="79">
                  <c:v>6.890472033</c:v>
                </c:pt>
                <c:pt idx="80">
                  <c:v>3.7027362670000001</c:v>
                </c:pt>
                <c:pt idx="81">
                  <c:v>3.4532414239999998</c:v>
                </c:pt>
                <c:pt idx="82">
                  <c:v>3.3628207259999998</c:v>
                </c:pt>
                <c:pt idx="83">
                  <c:v>3.805301144</c:v>
                </c:pt>
                <c:pt idx="84">
                  <c:v>4.320395435</c:v>
                </c:pt>
                <c:pt idx="85">
                  <c:v>6.9937410770000001</c:v>
                </c:pt>
                <c:pt idx="86">
                  <c:v>4.5029680809999997</c:v>
                </c:pt>
                <c:pt idx="87">
                  <c:v>3.0504610699999999</c:v>
                </c:pt>
                <c:pt idx="88">
                  <c:v>4.320395435</c:v>
                </c:pt>
                <c:pt idx="89">
                  <c:v>7.2810172900000003</c:v>
                </c:pt>
                <c:pt idx="90">
                  <c:v>2.7446986619999998</c:v>
                </c:pt>
                <c:pt idx="91">
                  <c:v>3.890562912</c:v>
                </c:pt>
                <c:pt idx="92">
                  <c:v>5.729183087</c:v>
                </c:pt>
                <c:pt idx="93">
                  <c:v>3.022672268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</c:numCache>
            </c:numRef>
          </c:val>
        </c:ser>
        <c:ser>
          <c:idx val="3"/>
          <c:order val="3"/>
          <c:tx>
            <c:strRef>
              <c:f>Late!$G$1</c:f>
              <c:strCache>
                <c:ptCount val="1"/>
                <c:pt idx="0">
                  <c:v>HPAT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Late!$G$2:$G$154</c:f>
              <c:numCache>
                <c:formatCode>General</c:formatCode>
                <c:ptCount val="15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6.5850011589999999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5.253656222</c:v>
                </c:pt>
                <c:pt idx="147">
                  <c:v>4.6219283710000001</c:v>
                </c:pt>
                <c:pt idx="148">
                  <c:v>3.7711505789999999</c:v>
                </c:pt>
                <c:pt idx="149">
                  <c:v>4.0289328949999996</c:v>
                </c:pt>
                <c:pt idx="150">
                  <c:v>4.6950531739999999</c:v>
                </c:pt>
                <c:pt idx="151">
                  <c:v>3.2549860480000001</c:v>
                </c:pt>
                <c:pt idx="152">
                  <c:v>4.0145788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7648664"/>
        <c:axId val="357650624"/>
      </c:radarChart>
      <c:catAx>
        <c:axId val="35764866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7650624"/>
        <c:crosses val="autoZero"/>
        <c:auto val="1"/>
        <c:lblAlgn val="ctr"/>
        <c:lblOffset val="100"/>
        <c:noMultiLvlLbl val="0"/>
      </c:catAx>
      <c:valAx>
        <c:axId val="357650624"/>
        <c:scaling>
          <c:orientation val="minMax"/>
          <c:max val="1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76486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BA0860-CD0F-4111-A88D-97823E48FAA2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26E606-3D27-4AB1-8873-A0DD79BBB6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197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8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HPAT21/HPAT115: 2 TERT(+) cells; HPAT21/HPAT2: 6 TET(+) cells; HPAT21/HPAT2/HPAT15:</a:t>
            </a:r>
            <a:r>
              <a:rPr lang="en-US" baseline="0" dirty="0" smtClean="0"/>
              <a:t> 9 TERT(+) cells;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877714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856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804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8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812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902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881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65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237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466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633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744470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84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1.xml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2.xml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3.xml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4.xml"/>
</Relationships>
</file>

<file path=ppt/slides/_rels/slide6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5.xml"/>
</Relationships>
</file>

<file path=ppt/slides/_rels/slide7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6.xml"/>
</Relationships>
</file>

<file path=ppt/slides/_rels/slide8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notesSlide" Target="../notesSlides/notesSlide1.xml"/>
   <Relationship Id="rId3" Type="http://schemas.openxmlformats.org/officeDocument/2006/relationships/chart" Target="../charts/chart7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82135" y="482139"/>
            <a:ext cx="11450471" cy="60324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2.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ingle-cell analysis of expression patterns of the lineage-specific genetic markers in HPAT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ncRNA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-defined sub-populations during human blastocyst differentiation. </a:t>
            </a:r>
          </a:p>
          <a:p>
            <a:pPr algn="ctr">
              <a:spcAft>
                <a:spcPts val="1000"/>
              </a:spcAft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changes of designated lineage-specific genetic markers (see text for details) were evaluated in individual cells comprising the corresponding HPAT expression-defined sub-populations that were recovered from the early-stage and late-stage human blastocysts. Differentiation patterns in human blastocyst cells of genetic markers of PE-like cells are shown in (A) and (C). Differentiation patterns of genetic markers of TE-like cells are shown in (B). Note that HPAT21 </a:t>
            </a:r>
            <a:r>
              <a:rPr lang="en-US" sz="14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+)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PAT15 (+ HPAT2 </a:t>
            </a:r>
            <a:r>
              <a:rPr lang="en-US" sz="14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-)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manifest gene expression differentiation patterns typical of PE-like cells (A), while HPAT21 </a:t>
            </a:r>
            <a:r>
              <a:rPr lang="en-US" sz="14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+)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PAT15 </a:t>
            </a:r>
            <a:r>
              <a:rPr lang="en-US" sz="14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-)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PAT2 </a:t>
            </a:r>
            <a:r>
              <a:rPr lang="en-US" sz="14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-)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exhibit gene expression differentiation patterns typical of TE-like cells (B). In contrast, no gene expression differentiation patterns resembling either PE-like or TE-like cells were observed in HPAT2 </a:t>
            </a:r>
            <a:r>
              <a:rPr lang="en-US" sz="14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+)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sub-populations (C). </a:t>
            </a:r>
          </a:p>
          <a:p>
            <a:pPr algn="ctr">
              <a:spcAft>
                <a:spcPts val="1000"/>
              </a:spcAft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 HPAT2 </a:t>
            </a:r>
            <a:r>
              <a:rPr lang="en-US" sz="14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+)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sub-populations manifest significant enrichment of cells expressing genetic markers of all three major lineages created during human blastocyst differentiation. . </a:t>
            </a:r>
          </a:p>
          <a:p>
            <a:pPr algn="ctr">
              <a:spcAft>
                <a:spcPts val="1000"/>
              </a:spcAft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HPAT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ncRNA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patterns in 241 individual human blastocyst cells. Each number on the circle designates one randomly placed blastocyst cell. </a:t>
            </a:r>
          </a:p>
          <a:p>
            <a:pPr algn="ctr">
              <a:spcAft>
                <a:spcPts val="1000"/>
              </a:spcAft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) HPAT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ncRNA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patterns in 88 individual cells recovered from the early-stage human blastocysts. Each number on the circle designates one randomly placed early-stage blastocyst cell. </a:t>
            </a:r>
          </a:p>
          <a:p>
            <a:pPr algn="ctr">
              <a:spcAft>
                <a:spcPts val="1000"/>
              </a:spcAft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G) HPAT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ncRNA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patterns in 153 individual cells recovered from the late-stage human blastocysts. Each number on the circle designates one randomly placed late-stage blastocyst cell. </a:t>
            </a:r>
          </a:p>
          <a:p>
            <a:pPr algn="ctr">
              <a:spcAft>
                <a:spcPts val="1000"/>
              </a:spcAft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the Figs. 2E-G each number on the circle corresponds to a single blastocyst cell. The colored lines inside the circle depict the corresponding 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PAT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ncRNAs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positions of the lines’ heights reflect the 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PAT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ncRNAs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’ expression values in corresponding cells. All human blastocyst cells are segregated into sub-groups based on common 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PAT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’ expression patterns (Fig. 1). The numbers of cells comprising the corresponding 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PAT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’s expression-defined sub-populations of the early (Fig. 2F) and late (Fig. 2G) blastocysts are shown. The statistical significance of the observed expression changes between sub-populations or within a sub-population during differentiation were estimated based on comparisons of the numbers of positive and negative cells using two-tailed Fisher’s exact test. Stars designate sub-populations harboring the significantly different numbers of cells expressing defined genetic markers. P values reported in the Supplemental Table S2.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62079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3525334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5-Point Star 4"/>
          <p:cNvSpPr/>
          <p:nvPr/>
        </p:nvSpPr>
        <p:spPr>
          <a:xfrm>
            <a:off x="6096000" y="2152935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" name="5-Point Star 5"/>
          <p:cNvSpPr/>
          <p:nvPr/>
        </p:nvSpPr>
        <p:spPr>
          <a:xfrm>
            <a:off x="5591032" y="5141795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" name="5-Point Star 6"/>
          <p:cNvSpPr/>
          <p:nvPr/>
        </p:nvSpPr>
        <p:spPr>
          <a:xfrm>
            <a:off x="8893791" y="4705067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" name="5-Point Star 7"/>
          <p:cNvSpPr/>
          <p:nvPr/>
        </p:nvSpPr>
        <p:spPr>
          <a:xfrm>
            <a:off x="9417982" y="5066732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7661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9376111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5-Point Star 3"/>
          <p:cNvSpPr/>
          <p:nvPr/>
        </p:nvSpPr>
        <p:spPr>
          <a:xfrm>
            <a:off x="6000465" y="2477696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" name="5-Point Star 7"/>
          <p:cNvSpPr/>
          <p:nvPr/>
        </p:nvSpPr>
        <p:spPr>
          <a:xfrm>
            <a:off x="5511421" y="3571792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7813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6515455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5-Point Star 3"/>
          <p:cNvSpPr/>
          <p:nvPr/>
        </p:nvSpPr>
        <p:spPr>
          <a:xfrm>
            <a:off x="4144370" y="4281986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41671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14756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3" name="5-Point Star 2"/>
          <p:cNvSpPr/>
          <p:nvPr/>
        </p:nvSpPr>
        <p:spPr>
          <a:xfrm>
            <a:off x="3284560" y="2221174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4" name="5-Point Star 3"/>
          <p:cNvSpPr/>
          <p:nvPr/>
        </p:nvSpPr>
        <p:spPr>
          <a:xfrm>
            <a:off x="3966949" y="2221174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" name="5-Point Star 4"/>
          <p:cNvSpPr/>
          <p:nvPr/>
        </p:nvSpPr>
        <p:spPr>
          <a:xfrm>
            <a:off x="4622040" y="1999397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" name="5-Point Star 6"/>
          <p:cNvSpPr/>
          <p:nvPr/>
        </p:nvSpPr>
        <p:spPr>
          <a:xfrm>
            <a:off x="7242412" y="4541293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" name="5-Point Star 7"/>
          <p:cNvSpPr/>
          <p:nvPr/>
        </p:nvSpPr>
        <p:spPr>
          <a:xfrm>
            <a:off x="8554872" y="1732129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9" name="5-Point Star 8"/>
          <p:cNvSpPr/>
          <p:nvPr/>
        </p:nvSpPr>
        <p:spPr>
          <a:xfrm>
            <a:off x="9223611" y="1472821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0" name="5-Point Star 9"/>
          <p:cNvSpPr/>
          <p:nvPr/>
        </p:nvSpPr>
        <p:spPr>
          <a:xfrm>
            <a:off x="6439467" y="3656465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1" name="5-Point Star 10"/>
          <p:cNvSpPr/>
          <p:nvPr/>
        </p:nvSpPr>
        <p:spPr>
          <a:xfrm>
            <a:off x="9714932" y="1063388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2" name="5-Point Star 11"/>
          <p:cNvSpPr/>
          <p:nvPr/>
        </p:nvSpPr>
        <p:spPr>
          <a:xfrm>
            <a:off x="7915701" y="2762534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3" name="5-Point Star 12"/>
          <p:cNvSpPr/>
          <p:nvPr/>
        </p:nvSpPr>
        <p:spPr>
          <a:xfrm>
            <a:off x="5904931" y="3001367"/>
            <a:ext cx="191069" cy="150125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1103084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 noGrp="1"/>
          </p:cNvGraphicFramePr>
          <p:nvPr>
            <p:extLst/>
          </p:nvPr>
        </p:nvGraphicFramePr>
        <p:xfrm>
          <a:off x="1764082" y="99779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542198" y="3429000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0070C0"/>
                </a:solidFill>
              </a:rPr>
              <a:t>HPAT21</a:t>
            </a:r>
            <a:endParaRPr lang="en-US" b="1" dirty="0">
              <a:solidFill>
                <a:srgbClr val="0070C0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784821" y="3429000"/>
            <a:ext cx="1729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PAT21/HPAT15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7455488" y="6388889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HPAT21/HPAT2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60718" y="6388889"/>
            <a:ext cx="2435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PAT21/HPAT2/HPAT15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 rot="18924285">
            <a:off x="7121132" y="1963160"/>
            <a:ext cx="6687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HPAT1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804140" y="880692"/>
            <a:ext cx="3088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</a:rPr>
              <a:t>Precursor cells &amp; ICM-like cell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99001" y="880692"/>
            <a:ext cx="29301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00B0F0"/>
                </a:solidFill>
              </a:rPr>
              <a:t>Precursor cells &amp; TE-like cells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 flipH="1">
            <a:off x="5854890" y="3613666"/>
            <a:ext cx="241111" cy="1395062"/>
          </a:xfrm>
          <a:prstGeom prst="straightConnector1">
            <a:avLst/>
          </a:prstGeom>
          <a:ln>
            <a:solidFill>
              <a:srgbClr val="00206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9483588" y="1661605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PAT15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0" y="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40432753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50664" y="2514599"/>
            <a:ext cx="17283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0070C0"/>
                </a:solidFill>
              </a:rPr>
              <a:t>HPAT21</a:t>
            </a:r>
          </a:p>
          <a:p>
            <a:pPr algn="ctr"/>
            <a:r>
              <a:rPr lang="en-US" b="1" dirty="0" smtClean="0">
                <a:solidFill>
                  <a:srgbClr val="0070C0"/>
                </a:solidFill>
              </a:rPr>
              <a:t>(33 cells; 37.5%)</a:t>
            </a:r>
            <a:endParaRPr lang="en-US" b="1" dirty="0">
              <a:solidFill>
                <a:srgbClr val="0070C0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457275" y="2514600"/>
            <a:ext cx="17299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HPAT21/HPAT15</a:t>
            </a:r>
          </a:p>
          <a:p>
            <a:pPr algn="ctr"/>
            <a:r>
              <a:rPr lang="en-US" b="1" dirty="0" smtClean="0"/>
              <a:t>(27 cells; 30.7%)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8391616" y="5883852"/>
            <a:ext cx="2975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HPAT21/HPAT2 (4 cells; 4.5%)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671166" y="6341464"/>
            <a:ext cx="40318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PAT21/HPAT2/HPAT15 (17 cells; 19.3%)</a:t>
            </a:r>
            <a:endParaRPr lang="en-US" b="1" dirty="0"/>
          </a:p>
        </p:txBody>
      </p:sp>
      <p:sp>
        <p:nvSpPr>
          <p:cNvPr id="7" name="Right Brace 6"/>
          <p:cNvSpPr/>
          <p:nvPr/>
        </p:nvSpPr>
        <p:spPr>
          <a:xfrm rot="3058250">
            <a:off x="7820488" y="5510887"/>
            <a:ext cx="413379" cy="656608"/>
          </a:xfrm>
          <a:prstGeom prst="rightBrac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9575095" y="4474312"/>
            <a:ext cx="14943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HPAT15</a:t>
            </a:r>
          </a:p>
          <a:p>
            <a:pPr algn="ctr"/>
            <a:r>
              <a:rPr lang="en-US" b="1" dirty="0" smtClean="0"/>
              <a:t>(6 cells; 6.8%)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 rot="1423082">
            <a:off x="6945811" y="4110475"/>
            <a:ext cx="6687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HPAT15</a:t>
            </a:r>
          </a:p>
        </p:txBody>
      </p:sp>
      <p:sp>
        <p:nvSpPr>
          <p:cNvPr id="11" name="Moon 10"/>
          <p:cNvSpPr/>
          <p:nvPr/>
        </p:nvSpPr>
        <p:spPr>
          <a:xfrm rot="9326939">
            <a:off x="8247430" y="589353"/>
            <a:ext cx="854694" cy="3624960"/>
          </a:xfrm>
          <a:prstGeom prst="moon">
            <a:avLst>
              <a:gd name="adj" fmla="val 5723"/>
            </a:avLst>
          </a:prstGeom>
          <a:solidFill>
            <a:srgbClr val="FFFF00"/>
          </a:solidFill>
          <a:ln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Moon 11"/>
          <p:cNvSpPr/>
          <p:nvPr/>
        </p:nvSpPr>
        <p:spPr>
          <a:xfrm rot="201871">
            <a:off x="2975541" y="881300"/>
            <a:ext cx="1480668" cy="4866539"/>
          </a:xfrm>
          <a:prstGeom prst="moon">
            <a:avLst>
              <a:gd name="adj" fmla="val 5723"/>
            </a:avLst>
          </a:prstGeom>
          <a:solidFill>
            <a:srgbClr val="00B0F0"/>
          </a:solidFill>
          <a:ln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8886936" y="647268"/>
            <a:ext cx="3088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</a:rPr>
              <a:t>Precursor cells &amp; ICM-like cell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60111" y="682829"/>
            <a:ext cx="29301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00B0F0"/>
                </a:solidFill>
              </a:rPr>
              <a:t>Precursor cells &amp; TE-like cells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111" y="1807775"/>
            <a:ext cx="2708049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70C0"/>
                </a:solidFill>
              </a:rPr>
              <a:t>CDX2/TROP2/TEAD4/YAP positive</a:t>
            </a:r>
          </a:p>
          <a:p>
            <a:pPr algn="ctr"/>
            <a:r>
              <a:rPr lang="en-US" sz="1400" b="1" dirty="0" smtClean="0">
                <a:solidFill>
                  <a:srgbClr val="0070C0"/>
                </a:solidFill>
              </a:rPr>
              <a:t>(9 cells; 10.2%)</a:t>
            </a:r>
            <a:endParaRPr lang="en-US" sz="1400" b="1" dirty="0">
              <a:solidFill>
                <a:srgbClr val="0070C0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118961" y="3447484"/>
            <a:ext cx="2752998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70C0"/>
                </a:solidFill>
              </a:rPr>
              <a:t>CDX2/TROP2/TEAD4/YAP negative</a:t>
            </a:r>
          </a:p>
          <a:p>
            <a:pPr algn="ctr"/>
            <a:r>
              <a:rPr lang="en-US" sz="1400" b="1" dirty="0" smtClean="0">
                <a:solidFill>
                  <a:srgbClr val="0070C0"/>
                </a:solidFill>
              </a:rPr>
              <a:t>(24 cells; 27.3%)</a:t>
            </a:r>
            <a:endParaRPr lang="en-US" sz="1400" b="1" dirty="0">
              <a:solidFill>
                <a:srgbClr val="0070C0"/>
              </a:solidFill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5254388" y="3616657"/>
            <a:ext cx="865430" cy="2170437"/>
          </a:xfrm>
          <a:prstGeom prst="straightConnector1">
            <a:avLst/>
          </a:prstGeom>
          <a:ln>
            <a:solidFill>
              <a:srgbClr val="00206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Oval 19"/>
          <p:cNvSpPr/>
          <p:nvPr/>
        </p:nvSpPr>
        <p:spPr>
          <a:xfrm rot="17744019">
            <a:off x="4938113" y="5949396"/>
            <a:ext cx="366267" cy="193583"/>
          </a:xfrm>
          <a:prstGeom prst="ellipse">
            <a:avLst/>
          </a:prstGeom>
          <a:solidFill>
            <a:schemeClr val="accent1">
              <a:alpha val="0"/>
            </a:schemeClr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1" name="Chart 20"/>
          <p:cNvGraphicFramePr>
            <a:graphicFrameLocks noGrp="1"/>
          </p:cNvGraphicFramePr>
          <p:nvPr>
            <p:extLst/>
          </p:nvPr>
        </p:nvGraphicFramePr>
        <p:xfrm>
          <a:off x="1782279" y="77804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567503" y="6020325"/>
            <a:ext cx="15531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solidFill>
                  <a:srgbClr val="FF0000"/>
                </a:solidFill>
              </a:rPr>
              <a:t>One TERT(+) cell</a:t>
            </a:r>
            <a:endParaRPr lang="en-US" sz="1600" b="1" i="1" dirty="0">
              <a:solidFill>
                <a:srgbClr val="FF0000"/>
              </a:solidFill>
            </a:endParaRPr>
          </a:p>
        </p:txBody>
      </p:sp>
      <p:cxnSp>
        <p:nvCxnSpPr>
          <p:cNvPr id="13" name="Straight Arrow Connector 12"/>
          <p:cNvCxnSpPr>
            <a:stCxn id="22" idx="3"/>
          </p:cNvCxnSpPr>
          <p:nvPr/>
        </p:nvCxnSpPr>
        <p:spPr>
          <a:xfrm flipV="1">
            <a:off x="2120685" y="6068519"/>
            <a:ext cx="2833855" cy="12108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0" y="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4166051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/>
          </p:nvPr>
        </p:nvGraphicFramePr>
        <p:xfrm>
          <a:off x="1764081" y="7446"/>
          <a:ext cx="8663836" cy="6289110"/>
        </p:xfrm>
        <a:graphic>
          <a:graphicData uri="http://schemas.openxmlformats.org/drawingml/2006/chart">
            <c:chart xmlns:c="http://schemas.openxmlformats.org/drawingml/2006/chart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49957" y="2505670"/>
            <a:ext cx="17283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0070C0"/>
                </a:solidFill>
              </a:rPr>
              <a:t>HPAT21</a:t>
            </a:r>
          </a:p>
          <a:p>
            <a:pPr algn="ctr"/>
            <a:r>
              <a:rPr lang="en-US" b="1" dirty="0" smtClean="0">
                <a:solidFill>
                  <a:srgbClr val="0070C0"/>
                </a:solidFill>
              </a:rPr>
              <a:t>(59 cells; 38.6%)</a:t>
            </a:r>
            <a:endParaRPr lang="en-US" b="1" dirty="0">
              <a:solidFill>
                <a:srgbClr val="0070C0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540261" y="6388889"/>
            <a:ext cx="3209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HPAT21/HPAT2 (21 cells; 13.7%)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74165" y="6383243"/>
            <a:ext cx="4084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PAT21/HPAT2/HPAT15 (16 cells; 10.5%) </a:t>
            </a:r>
            <a:endParaRPr lang="en-US" b="1" dirty="0"/>
          </a:p>
        </p:txBody>
      </p:sp>
      <p:sp>
        <p:nvSpPr>
          <p:cNvPr id="7" name="Right Brace 6"/>
          <p:cNvSpPr/>
          <p:nvPr/>
        </p:nvSpPr>
        <p:spPr>
          <a:xfrm rot="4112673">
            <a:off x="7032336" y="5040896"/>
            <a:ext cx="413379" cy="2351773"/>
          </a:xfrm>
          <a:prstGeom prst="rightBrac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Moon 8"/>
          <p:cNvSpPr/>
          <p:nvPr/>
        </p:nvSpPr>
        <p:spPr>
          <a:xfrm rot="9896512">
            <a:off x="7627506" y="551145"/>
            <a:ext cx="1657462" cy="4574240"/>
          </a:xfrm>
          <a:prstGeom prst="moon">
            <a:avLst>
              <a:gd name="adj" fmla="val 5723"/>
            </a:avLst>
          </a:prstGeom>
          <a:solidFill>
            <a:srgbClr val="FFFF00"/>
          </a:solidFill>
          <a:ln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9576584" y="2503174"/>
            <a:ext cx="17299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HPAT21/HPAT15</a:t>
            </a:r>
          </a:p>
          <a:p>
            <a:pPr algn="ctr"/>
            <a:r>
              <a:rPr lang="en-US" b="1" dirty="0" smtClean="0"/>
              <a:t>(57 cells; 37.3%)</a:t>
            </a:r>
            <a:endParaRPr lang="en-US" b="1" dirty="0"/>
          </a:p>
        </p:txBody>
      </p:sp>
      <p:sp>
        <p:nvSpPr>
          <p:cNvPr id="11" name="Moon 10"/>
          <p:cNvSpPr/>
          <p:nvPr/>
        </p:nvSpPr>
        <p:spPr>
          <a:xfrm rot="201871">
            <a:off x="2979572" y="878435"/>
            <a:ext cx="1379062" cy="4732170"/>
          </a:xfrm>
          <a:prstGeom prst="moon">
            <a:avLst>
              <a:gd name="adj" fmla="val 5723"/>
            </a:avLst>
          </a:prstGeom>
          <a:solidFill>
            <a:srgbClr val="00B0F0"/>
          </a:solidFill>
          <a:ln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10027521" y="1666498"/>
            <a:ext cx="828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PE-lik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250336" y="5336939"/>
            <a:ext cx="27084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</a:rPr>
              <a:t>EPIBLAST-like &amp; </a:t>
            </a:r>
          </a:p>
          <a:p>
            <a:pPr algn="ctr"/>
            <a:r>
              <a:rPr lang="en-US" b="1" dirty="0" smtClean="0">
                <a:solidFill>
                  <a:srgbClr val="FF0000"/>
                </a:solidFill>
              </a:rPr>
              <a:t>Ground-state pluripotency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897136" y="717157"/>
            <a:ext cx="3088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FF0000"/>
                </a:solidFill>
              </a:rPr>
              <a:t>Precursor cells &amp; ICM-like cell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60111" y="842045"/>
            <a:ext cx="29301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00B0F0"/>
                </a:solidFill>
              </a:rPr>
              <a:t>Precursor cells &amp; TE-like cells</a:t>
            </a:r>
          </a:p>
        </p:txBody>
      </p:sp>
      <p:sp>
        <p:nvSpPr>
          <p:cNvPr id="18" name="Rectangle 17"/>
          <p:cNvSpPr/>
          <p:nvPr/>
        </p:nvSpPr>
        <p:spPr>
          <a:xfrm>
            <a:off x="260111" y="1822214"/>
            <a:ext cx="2708049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70C0"/>
                </a:solidFill>
              </a:rPr>
              <a:t>CDX2/TROP2/TEAD4/YAP positive</a:t>
            </a:r>
          </a:p>
          <a:p>
            <a:pPr algn="ctr"/>
            <a:r>
              <a:rPr lang="en-US" sz="1400" b="1" dirty="0" smtClean="0">
                <a:solidFill>
                  <a:srgbClr val="0070C0"/>
                </a:solidFill>
              </a:rPr>
              <a:t>(36 cells; 23.5%)</a:t>
            </a:r>
            <a:endParaRPr lang="en-US" sz="1400" b="1" dirty="0">
              <a:solidFill>
                <a:srgbClr val="0070C0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178311" y="3640442"/>
            <a:ext cx="2752998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70C0"/>
                </a:solidFill>
              </a:rPr>
              <a:t>CDX2/TROP2/TEAD4/YAP negative</a:t>
            </a:r>
          </a:p>
          <a:p>
            <a:pPr algn="ctr"/>
            <a:r>
              <a:rPr lang="en-US" sz="1400" b="1" dirty="0" smtClean="0">
                <a:solidFill>
                  <a:srgbClr val="0070C0"/>
                </a:solidFill>
              </a:rPr>
              <a:t>(23 cells; 15.0%)</a:t>
            </a:r>
            <a:endParaRPr lang="en-US" sz="1400" b="1" dirty="0">
              <a:solidFill>
                <a:srgbClr val="0070C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871959" y="6020573"/>
            <a:ext cx="15628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solidFill>
                  <a:srgbClr val="FF0000"/>
                </a:solidFill>
              </a:rPr>
              <a:t>56% TERT(+) cell</a:t>
            </a:r>
            <a:endParaRPr lang="en-US" sz="1600" b="1" i="1" dirty="0">
              <a:solidFill>
                <a:srgbClr val="FF0000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491349" y="6020573"/>
            <a:ext cx="15628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solidFill>
                  <a:srgbClr val="FF0000"/>
                </a:solidFill>
              </a:rPr>
              <a:t>29% TERT(+) cell</a:t>
            </a:r>
            <a:endParaRPr lang="en-US" sz="1600" b="1" i="1" dirty="0">
              <a:solidFill>
                <a:srgbClr val="FF0000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9673502" y="3156706"/>
            <a:ext cx="16173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solidFill>
                  <a:srgbClr val="FF0000"/>
                </a:solidFill>
              </a:rPr>
              <a:t>3.5% TERT(+) cell</a:t>
            </a:r>
            <a:endParaRPr lang="en-US" sz="1600" b="1" i="1" dirty="0">
              <a:solidFill>
                <a:srgbClr val="FF0000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59999" y="3116507"/>
            <a:ext cx="14489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solidFill>
                  <a:srgbClr val="FF0000"/>
                </a:solidFill>
              </a:rPr>
              <a:t>No TERT(+) cell</a:t>
            </a:r>
            <a:endParaRPr lang="en-US" sz="1600" b="1" i="1" dirty="0">
              <a:solidFill>
                <a:srgbClr val="FF0000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0" y="-27295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352123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3</TotalTime>
  <Words>680</Words>
  <Application>Microsoft Office PowerPoint</Application>
  <PresentationFormat>Widescreen</PresentationFormat>
  <Paragraphs>70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